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6" r:id="rId2"/>
  </p:sldIdLst>
  <p:sldSz cx="6858000" cy="6308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94" autoAdjust="0"/>
    <p:restoredTop sz="94510" autoAdjust="0"/>
  </p:normalViewPr>
  <p:slideViewPr>
    <p:cSldViewPr>
      <p:cViewPr>
        <p:scale>
          <a:sx n="200" d="100"/>
          <a:sy n="200" d="100"/>
        </p:scale>
        <p:origin x="-2386" y="-48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182880" cy="18288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213-20260409T034642Z-3-001\protein_ligand213\protein_213\FINAL_RESULTS_MMPBSA-21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75-20260409T034459Z-3-001\protein_ligand75\protein_75\FINAL_RESULTS_MMPBSA-7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213-20260409T034642Z-3-001\protein_ligand213\protein_213\FINAL_RESULTS_MMPBSA-21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213-20260409T034642Z-3-001\protein_ligand213\protein_213\FINAL_DECOMP_MMPBSA_21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75-20260409T034459Z-3-001\protein_ligand75\protein_75\FINAL_RESULTS_MMPBSA-7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Zone\Desktop\Leu%20Nandi\PROJECT_SHIPON\MMGBSA\protein_ligand75-20260409T034459Z-3-001\protein_ligand75\protein_75\FINAL_DECOMP_MMPBSA_7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59014435382042"/>
          <c:y val="0.10115266361950372"/>
          <c:w val="0.82027041599836192"/>
          <c:h val="0.748461996052495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C00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D56-4474-8BB4-D70C39E434B2}"/>
              </c:ext>
            </c:extLst>
          </c:dPt>
          <c:dPt>
            <c:idx val="1"/>
            <c:invertIfNegative val="0"/>
            <c:bubble3D val="0"/>
            <c:spPr>
              <a:solidFill>
                <a:srgbClr val="33996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D56-4474-8BB4-D70C39E434B2}"/>
              </c:ext>
            </c:extLst>
          </c:dPt>
          <c:dPt>
            <c:idx val="2"/>
            <c:invertIfNegative val="0"/>
            <c:bubble3D val="0"/>
            <c:spPr>
              <a:solidFill>
                <a:srgbClr val="00808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D56-4474-8BB4-D70C39E434B2}"/>
              </c:ext>
            </c:extLst>
          </c:dPt>
          <c:dPt>
            <c:idx val="3"/>
            <c:invertIfNegative val="0"/>
            <c:bubble3D val="0"/>
            <c:spPr>
              <a:solidFill>
                <a:srgbClr val="66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D56-4474-8BB4-D70C39E434B2}"/>
              </c:ext>
            </c:extLst>
          </c:dPt>
          <c:dPt>
            <c:idx val="4"/>
            <c:invertIfNegative val="0"/>
            <c:bubble3D val="0"/>
            <c:spPr>
              <a:solidFill>
                <a:srgbClr val="99663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FD56-4474-8BB4-D70C39E434B2}"/>
              </c:ext>
            </c:extLst>
          </c:dPt>
          <c:dPt>
            <c:idx val="5"/>
            <c:invertIfNegative val="0"/>
            <c:bubble3D val="0"/>
            <c:spPr>
              <a:solidFill>
                <a:srgbClr val="3366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FD56-4474-8BB4-D70C39E434B2}"/>
              </c:ext>
            </c:extLst>
          </c:dPt>
          <c:dPt>
            <c:idx val="6"/>
            <c:invertIfNegative val="0"/>
            <c:bubble3D val="0"/>
            <c:spPr>
              <a:solidFill>
                <a:srgbClr val="99003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FD56-4474-8BB4-D70C39E434B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5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1"/>
            <c:plus>
              <c:numRef>
                <c:f>FINAL_RESULTS_MMPBSA!$U$615:$U$621</c:f>
                <c:numCache>
                  <c:formatCode>General</c:formatCode>
                  <c:ptCount val="7"/>
                  <c:pt idx="0">
                    <c:v>3.0800404515878759</c:v>
                  </c:pt>
                  <c:pt idx="1">
                    <c:v>6.4655409875204155</c:v>
                  </c:pt>
                  <c:pt idx="2">
                    <c:v>5.4859457966626479</c:v>
                  </c:pt>
                  <c:pt idx="3">
                    <c:v>0.41579891919776579</c:v>
                  </c:pt>
                  <c:pt idx="4">
                    <c:v>7.5425756527454588</c:v>
                  </c:pt>
                  <c:pt idx="5">
                    <c:v>5.2717427226838689</c:v>
                  </c:pt>
                  <c:pt idx="6">
                    <c:v>3.2184938126568503</c:v>
                  </c:pt>
                </c:numCache>
              </c:numRef>
            </c:plus>
            <c:minus>
              <c:numRef>
                <c:f>FINAL_RESULTS_MMPBSA!$U$615:$U$621</c:f>
                <c:numCache>
                  <c:formatCode>General</c:formatCode>
                  <c:ptCount val="7"/>
                  <c:pt idx="0">
                    <c:v>3.0800404515878759</c:v>
                  </c:pt>
                  <c:pt idx="1">
                    <c:v>6.4655409875204155</c:v>
                  </c:pt>
                  <c:pt idx="2">
                    <c:v>5.4859457966626479</c:v>
                  </c:pt>
                  <c:pt idx="3">
                    <c:v>0.41579891919776579</c:v>
                  </c:pt>
                  <c:pt idx="4">
                    <c:v>7.5425756527454588</c:v>
                  </c:pt>
                  <c:pt idx="5">
                    <c:v>5.2717427226838689</c:v>
                  </c:pt>
                  <c:pt idx="6">
                    <c:v>3.21849381265685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_RESULTS_MMPBSA!$S$615:$S$621</c:f>
              <c:strCache>
                <c:ptCount val="7"/>
                <c:pt idx="0">
                  <c:v>VDWAALS</c:v>
                </c:pt>
                <c:pt idx="1">
                  <c:v>EEL </c:v>
                </c:pt>
                <c:pt idx="2">
                  <c:v>EGB</c:v>
                </c:pt>
                <c:pt idx="3">
                  <c:v>ESURF</c:v>
                </c:pt>
                <c:pt idx="4">
                  <c:v>GGAS</c:v>
                </c:pt>
                <c:pt idx="5">
                  <c:v>GSOLV</c:v>
                </c:pt>
                <c:pt idx="6">
                  <c:v>TOTAL</c:v>
                </c:pt>
              </c:strCache>
            </c:strRef>
          </c:cat>
          <c:val>
            <c:numRef>
              <c:f>FINAL_RESULTS_MMPBSA!$T$615:$T$621</c:f>
              <c:numCache>
                <c:formatCode>General</c:formatCode>
                <c:ptCount val="7"/>
                <c:pt idx="0">
                  <c:v>-27.885249999999978</c:v>
                </c:pt>
                <c:pt idx="1">
                  <c:v>-8.5421999999999993</c:v>
                </c:pt>
                <c:pt idx="2">
                  <c:v>24.985849999999981</c:v>
                </c:pt>
                <c:pt idx="3">
                  <c:v>-4.1679500000000012</c:v>
                </c:pt>
                <c:pt idx="4">
                  <c:v>-36.427399999999977</c:v>
                </c:pt>
                <c:pt idx="5">
                  <c:v>20.817649999999993</c:v>
                </c:pt>
                <c:pt idx="6">
                  <c:v>-15.6097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FD56-4474-8BB4-D70C39E434B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7"/>
        <c:axId val="881774592"/>
        <c:axId val="881791392"/>
      </c:barChart>
      <c:catAx>
        <c:axId val="881774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81791392"/>
        <c:crosses val="autoZero"/>
        <c:auto val="1"/>
        <c:lblAlgn val="ctr"/>
        <c:lblOffset val="100"/>
        <c:noMultiLvlLbl val="0"/>
      </c:catAx>
      <c:valAx>
        <c:axId val="881791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1" i="0" u="none" strike="noStrike" kern="12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5176374567264202E-2"/>
              <c:y val="0.1602947671454930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81774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90416563843911"/>
          <c:y val="0.10182224504599589"/>
          <c:w val="0.82258058789171051"/>
          <c:h val="0.747792414626003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C33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EBC-40FD-BA9E-1336770C92E1}"/>
              </c:ext>
            </c:extLst>
          </c:dPt>
          <c:dPt>
            <c:idx val="1"/>
            <c:invertIfNegative val="0"/>
            <c:bubble3D val="0"/>
            <c:spPr>
              <a:solidFill>
                <a:srgbClr val="339966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EBC-40FD-BA9E-1336770C92E1}"/>
              </c:ext>
            </c:extLst>
          </c:dPt>
          <c:dPt>
            <c:idx val="2"/>
            <c:invertIfNegative val="0"/>
            <c:bubble3D val="0"/>
            <c:spPr>
              <a:solidFill>
                <a:srgbClr val="00808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EBC-40FD-BA9E-1336770C92E1}"/>
              </c:ext>
            </c:extLst>
          </c:dPt>
          <c:dPt>
            <c:idx val="3"/>
            <c:invertIfNegative val="0"/>
            <c:bubble3D val="0"/>
            <c:spPr>
              <a:solidFill>
                <a:srgbClr val="6600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EBC-40FD-BA9E-1336770C92E1}"/>
              </c:ext>
            </c:extLst>
          </c:dPt>
          <c:dPt>
            <c:idx val="4"/>
            <c:invertIfNegative val="0"/>
            <c:bubble3D val="0"/>
            <c:spPr>
              <a:solidFill>
                <a:srgbClr val="99663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EBC-40FD-BA9E-1336770C92E1}"/>
              </c:ext>
            </c:extLst>
          </c:dPt>
          <c:dPt>
            <c:idx val="5"/>
            <c:invertIfNegative val="0"/>
            <c:bubble3D val="0"/>
            <c:spPr>
              <a:solidFill>
                <a:srgbClr val="336699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CEBC-40FD-BA9E-1336770C92E1}"/>
              </c:ext>
            </c:extLst>
          </c:dPt>
          <c:dPt>
            <c:idx val="6"/>
            <c:invertIfNegative val="0"/>
            <c:bubble3D val="0"/>
            <c:spPr>
              <a:solidFill>
                <a:srgbClr val="99003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CEBC-40FD-BA9E-1336770C92E1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5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1"/>
            <c:plus>
              <c:numRef>
                <c:f>FINAL_RESULTS_MMPBSA!$U$614:$U$620</c:f>
                <c:numCache>
                  <c:formatCode>General</c:formatCode>
                  <c:ptCount val="7"/>
                  <c:pt idx="0">
                    <c:v>5.3109388924744625</c:v>
                  </c:pt>
                  <c:pt idx="1">
                    <c:v>11.806977902748024</c:v>
                  </c:pt>
                  <c:pt idx="2">
                    <c:v>11.657605218791133</c:v>
                  </c:pt>
                  <c:pt idx="3">
                    <c:v>0.66316553941177792</c:v>
                  </c:pt>
                  <c:pt idx="4">
                    <c:v>15.970353909587793</c:v>
                  </c:pt>
                  <c:pt idx="5">
                    <c:v>11.141768498148391</c:v>
                  </c:pt>
                  <c:pt idx="6">
                    <c:v>5.4485965838616011</c:v>
                  </c:pt>
                </c:numCache>
              </c:numRef>
            </c:plus>
            <c:minus>
              <c:numRef>
                <c:f>FINAL_RESULTS_MMPBSA!$U$614:$U$620</c:f>
                <c:numCache>
                  <c:formatCode>General</c:formatCode>
                  <c:ptCount val="7"/>
                  <c:pt idx="0">
                    <c:v>5.3109388924744625</c:v>
                  </c:pt>
                  <c:pt idx="1">
                    <c:v>11.806977902748024</c:v>
                  </c:pt>
                  <c:pt idx="2">
                    <c:v>11.657605218791133</c:v>
                  </c:pt>
                  <c:pt idx="3">
                    <c:v>0.66316553941177792</c:v>
                  </c:pt>
                  <c:pt idx="4">
                    <c:v>15.970353909587793</c:v>
                  </c:pt>
                  <c:pt idx="5">
                    <c:v>11.141768498148391</c:v>
                  </c:pt>
                  <c:pt idx="6">
                    <c:v>5.44859658386160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_RESULTS_MMPBSA!$S$614:$S$620</c:f>
              <c:strCache>
                <c:ptCount val="7"/>
                <c:pt idx="0">
                  <c:v>VDWAALS</c:v>
                </c:pt>
                <c:pt idx="1">
                  <c:v>EEL</c:v>
                </c:pt>
                <c:pt idx="2">
                  <c:v>EGB</c:v>
                </c:pt>
                <c:pt idx="3">
                  <c:v>ESURF</c:v>
                </c:pt>
                <c:pt idx="4">
                  <c:v>GGAS</c:v>
                </c:pt>
                <c:pt idx="5">
                  <c:v>GSOLV</c:v>
                </c:pt>
                <c:pt idx="6">
                  <c:v>TOTAL</c:v>
                </c:pt>
              </c:strCache>
            </c:strRef>
          </c:cat>
          <c:val>
            <c:numRef>
              <c:f>FINAL_RESULTS_MMPBSA!$T$614:$T$620</c:f>
              <c:numCache>
                <c:formatCode>General</c:formatCode>
                <c:ptCount val="7"/>
                <c:pt idx="0">
                  <c:v>-17.533800000000003</c:v>
                </c:pt>
                <c:pt idx="1">
                  <c:v>-12.75119999999999</c:v>
                </c:pt>
                <c:pt idx="2">
                  <c:v>18.849399999999992</c:v>
                </c:pt>
                <c:pt idx="3">
                  <c:v>-2.2971000000000008</c:v>
                </c:pt>
                <c:pt idx="4">
                  <c:v>-30.284850000000006</c:v>
                </c:pt>
                <c:pt idx="5">
                  <c:v>16.552599999999995</c:v>
                </c:pt>
                <c:pt idx="6">
                  <c:v>-13.7327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CEBC-40FD-BA9E-1336770C92E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00"/>
        <c:overlap val="-27"/>
        <c:axId val="912486687"/>
        <c:axId val="912491967"/>
      </c:barChart>
      <c:catAx>
        <c:axId val="912486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12491967"/>
        <c:crosses val="autoZero"/>
        <c:auto val="1"/>
        <c:lblAlgn val="ctr"/>
        <c:lblOffset val="100"/>
        <c:noMultiLvlLbl val="0"/>
      </c:catAx>
      <c:valAx>
        <c:axId val="912491967"/>
        <c:scaling>
          <c:orientation val="minMax"/>
          <c:min val="-5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1825652843145436E-2"/>
              <c:y val="0.1564947979765022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12486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46056488308384"/>
          <c:y val="5.0198620476937891E-2"/>
          <c:w val="0.81474475396807078"/>
          <c:h val="0.6373625389592138"/>
        </c:manualLayout>
      </c:layout>
      <c:scatterChart>
        <c:scatterStyle val="lineMarker"/>
        <c:varyColors val="0"/>
        <c:ser>
          <c:idx val="0"/>
          <c:order val="0"/>
          <c:spPr>
            <a:ln w="12700" cap="rnd">
              <a:solidFill>
                <a:srgbClr val="990033"/>
              </a:solidFill>
              <a:round/>
            </a:ln>
            <a:effectLst/>
          </c:spPr>
          <c:marker>
            <c:symbol val="none"/>
          </c:marker>
          <c:xVal>
            <c:numRef>
              <c:f>FINAL_RESULTS_MMPBSA!$A$613:$A$812</c:f>
              <c:numCache>
                <c:formatCode>General</c:formatCode>
                <c:ptCount val="200"/>
                <c:pt idx="0">
                  <c:v>1</c:v>
                </c:pt>
                <c:pt idx="1">
                  <c:v>101</c:v>
                </c:pt>
                <c:pt idx="2">
                  <c:v>201</c:v>
                </c:pt>
                <c:pt idx="3">
                  <c:v>301</c:v>
                </c:pt>
                <c:pt idx="4">
                  <c:v>401</c:v>
                </c:pt>
                <c:pt idx="5">
                  <c:v>501</c:v>
                </c:pt>
                <c:pt idx="6">
                  <c:v>601</c:v>
                </c:pt>
                <c:pt idx="7">
                  <c:v>701</c:v>
                </c:pt>
                <c:pt idx="8">
                  <c:v>801</c:v>
                </c:pt>
                <c:pt idx="9">
                  <c:v>901</c:v>
                </c:pt>
                <c:pt idx="10">
                  <c:v>1001</c:v>
                </c:pt>
                <c:pt idx="11">
                  <c:v>1101</c:v>
                </c:pt>
                <c:pt idx="12">
                  <c:v>1201</c:v>
                </c:pt>
                <c:pt idx="13">
                  <c:v>1301</c:v>
                </c:pt>
                <c:pt idx="14">
                  <c:v>1401</c:v>
                </c:pt>
                <c:pt idx="15">
                  <c:v>1501</c:v>
                </c:pt>
                <c:pt idx="16">
                  <c:v>1601</c:v>
                </c:pt>
                <c:pt idx="17">
                  <c:v>1701</c:v>
                </c:pt>
                <c:pt idx="18">
                  <c:v>1801</c:v>
                </c:pt>
                <c:pt idx="19">
                  <c:v>1901</c:v>
                </c:pt>
                <c:pt idx="20">
                  <c:v>2001</c:v>
                </c:pt>
                <c:pt idx="21">
                  <c:v>2101</c:v>
                </c:pt>
                <c:pt idx="22">
                  <c:v>2201</c:v>
                </c:pt>
                <c:pt idx="23">
                  <c:v>2301</c:v>
                </c:pt>
                <c:pt idx="24">
                  <c:v>2401</c:v>
                </c:pt>
                <c:pt idx="25">
                  <c:v>2501</c:v>
                </c:pt>
                <c:pt idx="26">
                  <c:v>2601</c:v>
                </c:pt>
                <c:pt idx="27">
                  <c:v>2701</c:v>
                </c:pt>
                <c:pt idx="28">
                  <c:v>2801</c:v>
                </c:pt>
                <c:pt idx="29">
                  <c:v>2901</c:v>
                </c:pt>
                <c:pt idx="30">
                  <c:v>3001</c:v>
                </c:pt>
                <c:pt idx="31">
                  <c:v>3101</c:v>
                </c:pt>
                <c:pt idx="32">
                  <c:v>3201</c:v>
                </c:pt>
                <c:pt idx="33">
                  <c:v>3301</c:v>
                </c:pt>
                <c:pt idx="34">
                  <c:v>3401</c:v>
                </c:pt>
                <c:pt idx="35">
                  <c:v>3501</c:v>
                </c:pt>
                <c:pt idx="36">
                  <c:v>3601</c:v>
                </c:pt>
                <c:pt idx="37">
                  <c:v>3701</c:v>
                </c:pt>
                <c:pt idx="38">
                  <c:v>3801</c:v>
                </c:pt>
                <c:pt idx="39">
                  <c:v>3901</c:v>
                </c:pt>
                <c:pt idx="40">
                  <c:v>4001</c:v>
                </c:pt>
                <c:pt idx="41">
                  <c:v>4101</c:v>
                </c:pt>
                <c:pt idx="42">
                  <c:v>4201</c:v>
                </c:pt>
                <c:pt idx="43">
                  <c:v>4301</c:v>
                </c:pt>
                <c:pt idx="44">
                  <c:v>4401</c:v>
                </c:pt>
                <c:pt idx="45">
                  <c:v>4501</c:v>
                </c:pt>
                <c:pt idx="46">
                  <c:v>4601</c:v>
                </c:pt>
                <c:pt idx="47">
                  <c:v>4701</c:v>
                </c:pt>
                <c:pt idx="48">
                  <c:v>4801</c:v>
                </c:pt>
                <c:pt idx="49">
                  <c:v>4901</c:v>
                </c:pt>
                <c:pt idx="50">
                  <c:v>5001</c:v>
                </c:pt>
                <c:pt idx="51">
                  <c:v>5101</c:v>
                </c:pt>
                <c:pt idx="52">
                  <c:v>5201</c:v>
                </c:pt>
                <c:pt idx="53">
                  <c:v>5301</c:v>
                </c:pt>
                <c:pt idx="54">
                  <c:v>5401</c:v>
                </c:pt>
                <c:pt idx="55">
                  <c:v>5501</c:v>
                </c:pt>
                <c:pt idx="56">
                  <c:v>5601</c:v>
                </c:pt>
                <c:pt idx="57">
                  <c:v>5701</c:v>
                </c:pt>
                <c:pt idx="58">
                  <c:v>5801</c:v>
                </c:pt>
                <c:pt idx="59">
                  <c:v>5901</c:v>
                </c:pt>
                <c:pt idx="60">
                  <c:v>6001</c:v>
                </c:pt>
                <c:pt idx="61">
                  <c:v>6101</c:v>
                </c:pt>
                <c:pt idx="62">
                  <c:v>6201</c:v>
                </c:pt>
                <c:pt idx="63">
                  <c:v>6301</c:v>
                </c:pt>
                <c:pt idx="64">
                  <c:v>6401</c:v>
                </c:pt>
                <c:pt idx="65">
                  <c:v>6501</c:v>
                </c:pt>
                <c:pt idx="66">
                  <c:v>6601</c:v>
                </c:pt>
                <c:pt idx="67">
                  <c:v>6701</c:v>
                </c:pt>
                <c:pt idx="68">
                  <c:v>6801</c:v>
                </c:pt>
                <c:pt idx="69">
                  <c:v>6901</c:v>
                </c:pt>
                <c:pt idx="70">
                  <c:v>7001</c:v>
                </c:pt>
                <c:pt idx="71">
                  <c:v>7101</c:v>
                </c:pt>
                <c:pt idx="72">
                  <c:v>7201</c:v>
                </c:pt>
                <c:pt idx="73">
                  <c:v>7301</c:v>
                </c:pt>
                <c:pt idx="74">
                  <c:v>7401</c:v>
                </c:pt>
                <c:pt idx="75">
                  <c:v>7501</c:v>
                </c:pt>
                <c:pt idx="76">
                  <c:v>7601</c:v>
                </c:pt>
                <c:pt idx="77">
                  <c:v>7701</c:v>
                </c:pt>
                <c:pt idx="78">
                  <c:v>7801</c:v>
                </c:pt>
                <c:pt idx="79">
                  <c:v>7901</c:v>
                </c:pt>
                <c:pt idx="80">
                  <c:v>8001</c:v>
                </c:pt>
                <c:pt idx="81">
                  <c:v>8101</c:v>
                </c:pt>
                <c:pt idx="82">
                  <c:v>8201</c:v>
                </c:pt>
                <c:pt idx="83">
                  <c:v>8301</c:v>
                </c:pt>
                <c:pt idx="84">
                  <c:v>8401</c:v>
                </c:pt>
                <c:pt idx="85">
                  <c:v>8501</c:v>
                </c:pt>
                <c:pt idx="86">
                  <c:v>8601</c:v>
                </c:pt>
                <c:pt idx="87">
                  <c:v>8701</c:v>
                </c:pt>
                <c:pt idx="88">
                  <c:v>8801</c:v>
                </c:pt>
                <c:pt idx="89">
                  <c:v>8901</c:v>
                </c:pt>
                <c:pt idx="90">
                  <c:v>9001</c:v>
                </c:pt>
                <c:pt idx="91">
                  <c:v>9101</c:v>
                </c:pt>
                <c:pt idx="92">
                  <c:v>9201</c:v>
                </c:pt>
                <c:pt idx="93">
                  <c:v>9301</c:v>
                </c:pt>
                <c:pt idx="94">
                  <c:v>9401</c:v>
                </c:pt>
                <c:pt idx="95">
                  <c:v>9501</c:v>
                </c:pt>
                <c:pt idx="96">
                  <c:v>9601</c:v>
                </c:pt>
                <c:pt idx="97">
                  <c:v>9701</c:v>
                </c:pt>
                <c:pt idx="98">
                  <c:v>9801</c:v>
                </c:pt>
                <c:pt idx="99">
                  <c:v>9901</c:v>
                </c:pt>
                <c:pt idx="100">
                  <c:v>10001</c:v>
                </c:pt>
                <c:pt idx="101">
                  <c:v>10101</c:v>
                </c:pt>
                <c:pt idx="102">
                  <c:v>10201</c:v>
                </c:pt>
                <c:pt idx="103">
                  <c:v>10301</c:v>
                </c:pt>
                <c:pt idx="104">
                  <c:v>10401</c:v>
                </c:pt>
                <c:pt idx="105">
                  <c:v>10501</c:v>
                </c:pt>
                <c:pt idx="106">
                  <c:v>10601</c:v>
                </c:pt>
                <c:pt idx="107">
                  <c:v>10701</c:v>
                </c:pt>
                <c:pt idx="108">
                  <c:v>10801</c:v>
                </c:pt>
                <c:pt idx="109">
                  <c:v>10901</c:v>
                </c:pt>
                <c:pt idx="110">
                  <c:v>11001</c:v>
                </c:pt>
                <c:pt idx="111">
                  <c:v>11101</c:v>
                </c:pt>
                <c:pt idx="112">
                  <c:v>11201</c:v>
                </c:pt>
                <c:pt idx="113">
                  <c:v>11301</c:v>
                </c:pt>
                <c:pt idx="114">
                  <c:v>11401</c:v>
                </c:pt>
                <c:pt idx="115">
                  <c:v>11501</c:v>
                </c:pt>
                <c:pt idx="116">
                  <c:v>11601</c:v>
                </c:pt>
                <c:pt idx="117">
                  <c:v>11701</c:v>
                </c:pt>
                <c:pt idx="118">
                  <c:v>11801</c:v>
                </c:pt>
                <c:pt idx="119">
                  <c:v>11901</c:v>
                </c:pt>
                <c:pt idx="120">
                  <c:v>12001</c:v>
                </c:pt>
                <c:pt idx="121">
                  <c:v>12101</c:v>
                </c:pt>
                <c:pt idx="122">
                  <c:v>12201</c:v>
                </c:pt>
                <c:pt idx="123">
                  <c:v>12301</c:v>
                </c:pt>
                <c:pt idx="124">
                  <c:v>12401</c:v>
                </c:pt>
                <c:pt idx="125">
                  <c:v>12501</c:v>
                </c:pt>
                <c:pt idx="126">
                  <c:v>12601</c:v>
                </c:pt>
                <c:pt idx="127">
                  <c:v>12701</c:v>
                </c:pt>
                <c:pt idx="128">
                  <c:v>12801</c:v>
                </c:pt>
                <c:pt idx="129">
                  <c:v>12901</c:v>
                </c:pt>
                <c:pt idx="130">
                  <c:v>13001</c:v>
                </c:pt>
                <c:pt idx="131">
                  <c:v>13101</c:v>
                </c:pt>
                <c:pt idx="132">
                  <c:v>13201</c:v>
                </c:pt>
                <c:pt idx="133">
                  <c:v>13301</c:v>
                </c:pt>
                <c:pt idx="134">
                  <c:v>13401</c:v>
                </c:pt>
                <c:pt idx="135">
                  <c:v>13501</c:v>
                </c:pt>
                <c:pt idx="136">
                  <c:v>13601</c:v>
                </c:pt>
                <c:pt idx="137">
                  <c:v>13701</c:v>
                </c:pt>
                <c:pt idx="138">
                  <c:v>13801</c:v>
                </c:pt>
                <c:pt idx="139">
                  <c:v>13901</c:v>
                </c:pt>
                <c:pt idx="140">
                  <c:v>14001</c:v>
                </c:pt>
                <c:pt idx="141">
                  <c:v>14101</c:v>
                </c:pt>
                <c:pt idx="142">
                  <c:v>14201</c:v>
                </c:pt>
                <c:pt idx="143">
                  <c:v>14301</c:v>
                </c:pt>
                <c:pt idx="144">
                  <c:v>14401</c:v>
                </c:pt>
                <c:pt idx="145">
                  <c:v>14501</c:v>
                </c:pt>
                <c:pt idx="146">
                  <c:v>14601</c:v>
                </c:pt>
                <c:pt idx="147">
                  <c:v>14701</c:v>
                </c:pt>
                <c:pt idx="148">
                  <c:v>14801</c:v>
                </c:pt>
                <c:pt idx="149">
                  <c:v>14901</c:v>
                </c:pt>
                <c:pt idx="150">
                  <c:v>15001</c:v>
                </c:pt>
                <c:pt idx="151">
                  <c:v>15101</c:v>
                </c:pt>
                <c:pt idx="152">
                  <c:v>15201</c:v>
                </c:pt>
                <c:pt idx="153">
                  <c:v>15301</c:v>
                </c:pt>
                <c:pt idx="154">
                  <c:v>15401</c:v>
                </c:pt>
                <c:pt idx="155">
                  <c:v>15501</c:v>
                </c:pt>
                <c:pt idx="156">
                  <c:v>15601</c:v>
                </c:pt>
                <c:pt idx="157">
                  <c:v>15701</c:v>
                </c:pt>
                <c:pt idx="158">
                  <c:v>15801</c:v>
                </c:pt>
                <c:pt idx="159">
                  <c:v>15901</c:v>
                </c:pt>
                <c:pt idx="160">
                  <c:v>16001</c:v>
                </c:pt>
                <c:pt idx="161">
                  <c:v>16101</c:v>
                </c:pt>
                <c:pt idx="162">
                  <c:v>16201</c:v>
                </c:pt>
                <c:pt idx="163">
                  <c:v>16301</c:v>
                </c:pt>
                <c:pt idx="164">
                  <c:v>16401</c:v>
                </c:pt>
                <c:pt idx="165">
                  <c:v>16501</c:v>
                </c:pt>
                <c:pt idx="166">
                  <c:v>16601</c:v>
                </c:pt>
                <c:pt idx="167">
                  <c:v>16701</c:v>
                </c:pt>
                <c:pt idx="168">
                  <c:v>16801</c:v>
                </c:pt>
                <c:pt idx="169">
                  <c:v>16901</c:v>
                </c:pt>
                <c:pt idx="170">
                  <c:v>17001</c:v>
                </c:pt>
                <c:pt idx="171">
                  <c:v>17101</c:v>
                </c:pt>
                <c:pt idx="172">
                  <c:v>17201</c:v>
                </c:pt>
                <c:pt idx="173">
                  <c:v>17301</c:v>
                </c:pt>
                <c:pt idx="174">
                  <c:v>17401</c:v>
                </c:pt>
                <c:pt idx="175">
                  <c:v>17501</c:v>
                </c:pt>
                <c:pt idx="176">
                  <c:v>17601</c:v>
                </c:pt>
                <c:pt idx="177">
                  <c:v>17701</c:v>
                </c:pt>
                <c:pt idx="178">
                  <c:v>17801</c:v>
                </c:pt>
                <c:pt idx="179">
                  <c:v>17901</c:v>
                </c:pt>
                <c:pt idx="180">
                  <c:v>18001</c:v>
                </c:pt>
                <c:pt idx="181">
                  <c:v>18101</c:v>
                </c:pt>
                <c:pt idx="182">
                  <c:v>18201</c:v>
                </c:pt>
                <c:pt idx="183">
                  <c:v>18301</c:v>
                </c:pt>
                <c:pt idx="184">
                  <c:v>18401</c:v>
                </c:pt>
                <c:pt idx="185">
                  <c:v>18501</c:v>
                </c:pt>
                <c:pt idx="186">
                  <c:v>18601</c:v>
                </c:pt>
                <c:pt idx="187">
                  <c:v>18701</c:v>
                </c:pt>
                <c:pt idx="188">
                  <c:v>18801</c:v>
                </c:pt>
                <c:pt idx="189">
                  <c:v>18901</c:v>
                </c:pt>
                <c:pt idx="190">
                  <c:v>19001</c:v>
                </c:pt>
                <c:pt idx="191">
                  <c:v>19101</c:v>
                </c:pt>
                <c:pt idx="192">
                  <c:v>19201</c:v>
                </c:pt>
                <c:pt idx="193">
                  <c:v>19301</c:v>
                </c:pt>
                <c:pt idx="194">
                  <c:v>19401</c:v>
                </c:pt>
                <c:pt idx="195">
                  <c:v>19501</c:v>
                </c:pt>
                <c:pt idx="196">
                  <c:v>19601</c:v>
                </c:pt>
                <c:pt idx="197">
                  <c:v>19701</c:v>
                </c:pt>
                <c:pt idx="198">
                  <c:v>19801</c:v>
                </c:pt>
                <c:pt idx="199">
                  <c:v>19901</c:v>
                </c:pt>
              </c:numCache>
            </c:numRef>
          </c:xVal>
          <c:yVal>
            <c:numRef>
              <c:f>FINAL_RESULTS_MMPBSA!$P$613:$P$812</c:f>
              <c:numCache>
                <c:formatCode>General</c:formatCode>
                <c:ptCount val="200"/>
                <c:pt idx="0">
                  <c:v>-23.83</c:v>
                </c:pt>
                <c:pt idx="1">
                  <c:v>-15.52</c:v>
                </c:pt>
                <c:pt idx="2">
                  <c:v>-23.2</c:v>
                </c:pt>
                <c:pt idx="3">
                  <c:v>-19.07</c:v>
                </c:pt>
                <c:pt idx="4">
                  <c:v>-18.190000000000001</c:v>
                </c:pt>
                <c:pt idx="5">
                  <c:v>-20.58</c:v>
                </c:pt>
                <c:pt idx="6">
                  <c:v>-19.61</c:v>
                </c:pt>
                <c:pt idx="7">
                  <c:v>-19.27</c:v>
                </c:pt>
                <c:pt idx="8">
                  <c:v>-21.89</c:v>
                </c:pt>
                <c:pt idx="9">
                  <c:v>-16.29</c:v>
                </c:pt>
                <c:pt idx="10">
                  <c:v>-12.28</c:v>
                </c:pt>
                <c:pt idx="11">
                  <c:v>-14.97</c:v>
                </c:pt>
                <c:pt idx="12">
                  <c:v>-15.99</c:v>
                </c:pt>
                <c:pt idx="13">
                  <c:v>-17.84</c:v>
                </c:pt>
                <c:pt idx="14">
                  <c:v>-18.68</c:v>
                </c:pt>
                <c:pt idx="15">
                  <c:v>-15.72</c:v>
                </c:pt>
                <c:pt idx="16">
                  <c:v>-22.3</c:v>
                </c:pt>
                <c:pt idx="17">
                  <c:v>-16.850000000000001</c:v>
                </c:pt>
                <c:pt idx="18">
                  <c:v>-12.89</c:v>
                </c:pt>
                <c:pt idx="19">
                  <c:v>-16.52</c:v>
                </c:pt>
                <c:pt idx="20">
                  <c:v>-14.06</c:v>
                </c:pt>
                <c:pt idx="21">
                  <c:v>-16.309999999999999</c:v>
                </c:pt>
                <c:pt idx="22">
                  <c:v>-16.260000000000002</c:v>
                </c:pt>
                <c:pt idx="23">
                  <c:v>-14.18</c:v>
                </c:pt>
                <c:pt idx="24">
                  <c:v>-14.83</c:v>
                </c:pt>
                <c:pt idx="25">
                  <c:v>-14.27</c:v>
                </c:pt>
                <c:pt idx="26">
                  <c:v>-13.84</c:v>
                </c:pt>
                <c:pt idx="27">
                  <c:v>-13.73</c:v>
                </c:pt>
                <c:pt idx="28">
                  <c:v>-18.78</c:v>
                </c:pt>
                <c:pt idx="29">
                  <c:v>-17.059999999999999</c:v>
                </c:pt>
                <c:pt idx="30">
                  <c:v>-18.149999999999999</c:v>
                </c:pt>
                <c:pt idx="31">
                  <c:v>-12.56</c:v>
                </c:pt>
                <c:pt idx="32">
                  <c:v>-17.41</c:v>
                </c:pt>
                <c:pt idx="33">
                  <c:v>-17.350000000000001</c:v>
                </c:pt>
                <c:pt idx="34">
                  <c:v>-16.399999999999999</c:v>
                </c:pt>
                <c:pt idx="35">
                  <c:v>-18.010000000000002</c:v>
                </c:pt>
                <c:pt idx="36">
                  <c:v>-14.8</c:v>
                </c:pt>
                <c:pt idx="37">
                  <c:v>-13.86</c:v>
                </c:pt>
                <c:pt idx="38">
                  <c:v>-20.87</c:v>
                </c:pt>
                <c:pt idx="39">
                  <c:v>-17.79</c:v>
                </c:pt>
                <c:pt idx="40">
                  <c:v>-18.170000000000002</c:v>
                </c:pt>
                <c:pt idx="41">
                  <c:v>-12.62</c:v>
                </c:pt>
                <c:pt idx="42">
                  <c:v>-17.88</c:v>
                </c:pt>
                <c:pt idx="43">
                  <c:v>-13.24</c:v>
                </c:pt>
                <c:pt idx="44">
                  <c:v>-18.88</c:v>
                </c:pt>
                <c:pt idx="45">
                  <c:v>-19.399999999999999</c:v>
                </c:pt>
                <c:pt idx="46">
                  <c:v>-16.32</c:v>
                </c:pt>
                <c:pt idx="47">
                  <c:v>-18.38</c:v>
                </c:pt>
                <c:pt idx="48">
                  <c:v>-19.079999999999998</c:v>
                </c:pt>
                <c:pt idx="49">
                  <c:v>-14.87</c:v>
                </c:pt>
                <c:pt idx="50">
                  <c:v>-14.67</c:v>
                </c:pt>
                <c:pt idx="51">
                  <c:v>-15.1</c:v>
                </c:pt>
                <c:pt idx="52">
                  <c:v>-17.510000000000002</c:v>
                </c:pt>
                <c:pt idx="53">
                  <c:v>-16.13</c:v>
                </c:pt>
                <c:pt idx="54">
                  <c:v>-16.309999999999999</c:v>
                </c:pt>
                <c:pt idx="55">
                  <c:v>-9.66</c:v>
                </c:pt>
                <c:pt idx="56">
                  <c:v>-14.91</c:v>
                </c:pt>
                <c:pt idx="57">
                  <c:v>-15.3</c:v>
                </c:pt>
                <c:pt idx="58">
                  <c:v>-20.05</c:v>
                </c:pt>
                <c:pt idx="59">
                  <c:v>-21.95</c:v>
                </c:pt>
                <c:pt idx="60">
                  <c:v>-25</c:v>
                </c:pt>
                <c:pt idx="61">
                  <c:v>-16.79</c:v>
                </c:pt>
                <c:pt idx="62">
                  <c:v>-16.43</c:v>
                </c:pt>
                <c:pt idx="63">
                  <c:v>-20.48</c:v>
                </c:pt>
                <c:pt idx="64">
                  <c:v>-16.63</c:v>
                </c:pt>
                <c:pt idx="65">
                  <c:v>-19.2</c:v>
                </c:pt>
                <c:pt idx="66">
                  <c:v>-11.06</c:v>
                </c:pt>
                <c:pt idx="67">
                  <c:v>-15.97</c:v>
                </c:pt>
                <c:pt idx="68">
                  <c:v>-17.96</c:v>
                </c:pt>
                <c:pt idx="69">
                  <c:v>-19.95</c:v>
                </c:pt>
                <c:pt idx="70">
                  <c:v>-17.12</c:v>
                </c:pt>
                <c:pt idx="71">
                  <c:v>-18.670000000000002</c:v>
                </c:pt>
                <c:pt idx="72">
                  <c:v>-16.190000000000001</c:v>
                </c:pt>
                <c:pt idx="73">
                  <c:v>-18.579999999999998</c:v>
                </c:pt>
                <c:pt idx="74">
                  <c:v>-16.010000000000002</c:v>
                </c:pt>
                <c:pt idx="75">
                  <c:v>-14.44</c:v>
                </c:pt>
                <c:pt idx="76">
                  <c:v>-16.22</c:v>
                </c:pt>
                <c:pt idx="77">
                  <c:v>-16.2</c:v>
                </c:pt>
                <c:pt idx="78">
                  <c:v>-18.12</c:v>
                </c:pt>
                <c:pt idx="79">
                  <c:v>-21.49</c:v>
                </c:pt>
                <c:pt idx="80">
                  <c:v>-19.46</c:v>
                </c:pt>
                <c:pt idx="81">
                  <c:v>-22.52</c:v>
                </c:pt>
                <c:pt idx="82">
                  <c:v>-24.04</c:v>
                </c:pt>
                <c:pt idx="83">
                  <c:v>-22.66</c:v>
                </c:pt>
                <c:pt idx="84">
                  <c:v>-12.66</c:v>
                </c:pt>
                <c:pt idx="85">
                  <c:v>-15.38</c:v>
                </c:pt>
                <c:pt idx="86">
                  <c:v>-12.48</c:v>
                </c:pt>
                <c:pt idx="87">
                  <c:v>-15.99</c:v>
                </c:pt>
                <c:pt idx="88">
                  <c:v>-17.829999999999998</c:v>
                </c:pt>
                <c:pt idx="89">
                  <c:v>-15.29</c:v>
                </c:pt>
                <c:pt idx="90">
                  <c:v>-9.6999999999999993</c:v>
                </c:pt>
                <c:pt idx="91">
                  <c:v>-14.87</c:v>
                </c:pt>
                <c:pt idx="92">
                  <c:v>-16.329999999999998</c:v>
                </c:pt>
                <c:pt idx="93">
                  <c:v>-13.94</c:v>
                </c:pt>
                <c:pt idx="94">
                  <c:v>-11.23</c:v>
                </c:pt>
                <c:pt idx="95">
                  <c:v>-12.13</c:v>
                </c:pt>
                <c:pt idx="96">
                  <c:v>-14.12</c:v>
                </c:pt>
                <c:pt idx="97">
                  <c:v>-13.99</c:v>
                </c:pt>
                <c:pt idx="98">
                  <c:v>-17.079999999999998</c:v>
                </c:pt>
                <c:pt idx="99">
                  <c:v>-13.77</c:v>
                </c:pt>
                <c:pt idx="100">
                  <c:v>-12.14</c:v>
                </c:pt>
                <c:pt idx="101">
                  <c:v>-19.989999999999998</c:v>
                </c:pt>
                <c:pt idx="102">
                  <c:v>-22.34</c:v>
                </c:pt>
                <c:pt idx="103">
                  <c:v>-17.170000000000002</c:v>
                </c:pt>
                <c:pt idx="104">
                  <c:v>-15.5</c:v>
                </c:pt>
                <c:pt idx="105">
                  <c:v>-20.07</c:v>
                </c:pt>
                <c:pt idx="106">
                  <c:v>-11.87</c:v>
                </c:pt>
                <c:pt idx="107">
                  <c:v>-13.27</c:v>
                </c:pt>
                <c:pt idx="108">
                  <c:v>-12.33</c:v>
                </c:pt>
                <c:pt idx="109">
                  <c:v>-15.65</c:v>
                </c:pt>
                <c:pt idx="110">
                  <c:v>-15.57</c:v>
                </c:pt>
                <c:pt idx="111">
                  <c:v>-17.41</c:v>
                </c:pt>
                <c:pt idx="112">
                  <c:v>-17.43</c:v>
                </c:pt>
                <c:pt idx="113">
                  <c:v>-11.53</c:v>
                </c:pt>
                <c:pt idx="114">
                  <c:v>-14.89</c:v>
                </c:pt>
                <c:pt idx="115">
                  <c:v>-11.15</c:v>
                </c:pt>
                <c:pt idx="116">
                  <c:v>-15.91</c:v>
                </c:pt>
                <c:pt idx="117">
                  <c:v>-18.88</c:v>
                </c:pt>
                <c:pt idx="118">
                  <c:v>-14.03</c:v>
                </c:pt>
                <c:pt idx="119">
                  <c:v>-16.98</c:v>
                </c:pt>
                <c:pt idx="120">
                  <c:v>-18.36</c:v>
                </c:pt>
                <c:pt idx="121">
                  <c:v>-18.18</c:v>
                </c:pt>
                <c:pt idx="122">
                  <c:v>-16.05</c:v>
                </c:pt>
                <c:pt idx="123">
                  <c:v>-16.36</c:v>
                </c:pt>
                <c:pt idx="124">
                  <c:v>-19.47</c:v>
                </c:pt>
                <c:pt idx="125">
                  <c:v>-17.84</c:v>
                </c:pt>
                <c:pt idx="126">
                  <c:v>-20.95</c:v>
                </c:pt>
                <c:pt idx="127">
                  <c:v>-17.37</c:v>
                </c:pt>
                <c:pt idx="128">
                  <c:v>-18.670000000000002</c:v>
                </c:pt>
                <c:pt idx="129">
                  <c:v>-14.29</c:v>
                </c:pt>
                <c:pt idx="130">
                  <c:v>-18.87</c:v>
                </c:pt>
                <c:pt idx="131">
                  <c:v>-20.36</c:v>
                </c:pt>
                <c:pt idx="132">
                  <c:v>-12.27</c:v>
                </c:pt>
                <c:pt idx="133">
                  <c:v>-14.57</c:v>
                </c:pt>
                <c:pt idx="134">
                  <c:v>-17.28</c:v>
                </c:pt>
                <c:pt idx="135">
                  <c:v>-18.579999999999998</c:v>
                </c:pt>
                <c:pt idx="136">
                  <c:v>-16.39</c:v>
                </c:pt>
                <c:pt idx="137">
                  <c:v>-15.75</c:v>
                </c:pt>
                <c:pt idx="138">
                  <c:v>-13.99</c:v>
                </c:pt>
                <c:pt idx="139">
                  <c:v>-13.07</c:v>
                </c:pt>
                <c:pt idx="140">
                  <c:v>-14.37</c:v>
                </c:pt>
                <c:pt idx="141">
                  <c:v>-11.7</c:v>
                </c:pt>
                <c:pt idx="142">
                  <c:v>-9.7799999999999994</c:v>
                </c:pt>
                <c:pt idx="143">
                  <c:v>-11.12</c:v>
                </c:pt>
                <c:pt idx="144">
                  <c:v>-10.029999999999999</c:v>
                </c:pt>
                <c:pt idx="145">
                  <c:v>-12.13</c:v>
                </c:pt>
                <c:pt idx="146">
                  <c:v>-12.06</c:v>
                </c:pt>
                <c:pt idx="147">
                  <c:v>-10.84</c:v>
                </c:pt>
                <c:pt idx="148">
                  <c:v>-14.69</c:v>
                </c:pt>
                <c:pt idx="149">
                  <c:v>-14.14</c:v>
                </c:pt>
                <c:pt idx="150">
                  <c:v>-13.49</c:v>
                </c:pt>
                <c:pt idx="151">
                  <c:v>-10.01</c:v>
                </c:pt>
                <c:pt idx="152">
                  <c:v>-10.61</c:v>
                </c:pt>
                <c:pt idx="153">
                  <c:v>-10.75</c:v>
                </c:pt>
                <c:pt idx="154">
                  <c:v>-13.12</c:v>
                </c:pt>
                <c:pt idx="155">
                  <c:v>-13.09</c:v>
                </c:pt>
                <c:pt idx="156">
                  <c:v>-12.27</c:v>
                </c:pt>
                <c:pt idx="157">
                  <c:v>-13.35</c:v>
                </c:pt>
                <c:pt idx="158">
                  <c:v>-12.46</c:v>
                </c:pt>
                <c:pt idx="159">
                  <c:v>-13.34</c:v>
                </c:pt>
                <c:pt idx="160">
                  <c:v>-16.64</c:v>
                </c:pt>
                <c:pt idx="161">
                  <c:v>-15.93</c:v>
                </c:pt>
                <c:pt idx="162">
                  <c:v>-12.42</c:v>
                </c:pt>
                <c:pt idx="163">
                  <c:v>-13.93</c:v>
                </c:pt>
                <c:pt idx="164">
                  <c:v>-12.51</c:v>
                </c:pt>
                <c:pt idx="165">
                  <c:v>-13.48</c:v>
                </c:pt>
                <c:pt idx="166">
                  <c:v>-13.5</c:v>
                </c:pt>
                <c:pt idx="167">
                  <c:v>-11.99</c:v>
                </c:pt>
                <c:pt idx="168">
                  <c:v>-13.69</c:v>
                </c:pt>
                <c:pt idx="169">
                  <c:v>-11.04</c:v>
                </c:pt>
                <c:pt idx="170">
                  <c:v>-10.8</c:v>
                </c:pt>
                <c:pt idx="171">
                  <c:v>-12.97</c:v>
                </c:pt>
                <c:pt idx="172">
                  <c:v>-13.01</c:v>
                </c:pt>
                <c:pt idx="173">
                  <c:v>-16.18</c:v>
                </c:pt>
                <c:pt idx="174">
                  <c:v>-11.87</c:v>
                </c:pt>
                <c:pt idx="175">
                  <c:v>-11.52</c:v>
                </c:pt>
                <c:pt idx="176">
                  <c:v>-17.55</c:v>
                </c:pt>
                <c:pt idx="177">
                  <c:v>-12.12</c:v>
                </c:pt>
                <c:pt idx="178">
                  <c:v>-15.57</c:v>
                </c:pt>
                <c:pt idx="179">
                  <c:v>-18.579999999999998</c:v>
                </c:pt>
                <c:pt idx="180">
                  <c:v>-18.82</c:v>
                </c:pt>
                <c:pt idx="181">
                  <c:v>-14.3</c:v>
                </c:pt>
                <c:pt idx="182">
                  <c:v>-12.09</c:v>
                </c:pt>
                <c:pt idx="183">
                  <c:v>-11.17</c:v>
                </c:pt>
                <c:pt idx="184">
                  <c:v>-15.55</c:v>
                </c:pt>
                <c:pt idx="185">
                  <c:v>-10.64</c:v>
                </c:pt>
                <c:pt idx="186">
                  <c:v>-12.57</c:v>
                </c:pt>
                <c:pt idx="187">
                  <c:v>-16.079999999999998</c:v>
                </c:pt>
                <c:pt idx="188">
                  <c:v>-14.37</c:v>
                </c:pt>
                <c:pt idx="189">
                  <c:v>-12.09</c:v>
                </c:pt>
                <c:pt idx="190">
                  <c:v>-10.48</c:v>
                </c:pt>
                <c:pt idx="191">
                  <c:v>-10.48</c:v>
                </c:pt>
                <c:pt idx="192">
                  <c:v>-15.29</c:v>
                </c:pt>
                <c:pt idx="193">
                  <c:v>-13.91</c:v>
                </c:pt>
                <c:pt idx="194">
                  <c:v>-13.57</c:v>
                </c:pt>
                <c:pt idx="195">
                  <c:v>-12.21</c:v>
                </c:pt>
                <c:pt idx="196">
                  <c:v>-13.47</c:v>
                </c:pt>
                <c:pt idx="197">
                  <c:v>-12.63</c:v>
                </c:pt>
                <c:pt idx="198">
                  <c:v>-14.8</c:v>
                </c:pt>
                <c:pt idx="199">
                  <c:v>-15.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F3C-43FD-BE64-4DE11D18DB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62410751"/>
        <c:axId val="1662395871"/>
      </c:scatterChart>
      <c:valAx>
        <c:axId val="1662410751"/>
        <c:scaling>
          <c:orientation val="minMax"/>
          <c:max val="20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mes</a:t>
                </a:r>
              </a:p>
            </c:rich>
          </c:tx>
          <c:layout>
            <c:manualLayout>
              <c:xMode val="edge"/>
              <c:yMode val="edge"/>
              <c:x val="0.49818440159521737"/>
              <c:y val="0.875360862438218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3175" cap="flat" cmpd="sng" algn="ctr">
            <a:noFill/>
            <a:round/>
          </a:ln>
          <a:effectLst/>
        </c:spPr>
        <c:txPr>
          <a:bodyPr rot="-5400000" spcFirstLastPara="1" vertOverflow="ellipsis" wrap="square" anchor="b" anchorCtr="0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2395871"/>
        <c:crosses val="autoZero"/>
        <c:crossBetween val="midCat"/>
        <c:majorUnit val="2000"/>
      </c:valAx>
      <c:valAx>
        <c:axId val="1662395871"/>
        <c:scaling>
          <c:orientation val="minMax"/>
          <c:min val="-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5031355763193418E-2"/>
              <c:y val="0.1085380687174614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2410751"/>
        <c:crosses val="autoZero"/>
        <c:crossBetween val="midCat"/>
        <c:majorUnit val="5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2526528271673"/>
          <c:y val="5.6710500313691341E-2"/>
          <c:w val="0.808180667427703"/>
          <c:h val="0.755325557881326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666699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NAL_DECOMP_MMPBSA!$S$10:$S$28</c:f>
                <c:numCache>
                  <c:formatCode>General</c:formatCode>
                  <c:ptCount val="19"/>
                  <c:pt idx="0">
                    <c:v>3.5999104207916001E-2</c:v>
                  </c:pt>
                  <c:pt idx="1">
                    <c:v>4.3045387292708702E-2</c:v>
                  </c:pt>
                  <c:pt idx="2">
                    <c:v>3.2423512188104998E-2</c:v>
                  </c:pt>
                  <c:pt idx="3">
                    <c:v>4.2366827809697097E-2</c:v>
                  </c:pt>
                  <c:pt idx="4">
                    <c:v>5.5660128902759301E-2</c:v>
                  </c:pt>
                  <c:pt idx="5">
                    <c:v>7.7669307671570001E-2</c:v>
                  </c:pt>
                  <c:pt idx="6">
                    <c:v>3.2625058349261001E-2</c:v>
                  </c:pt>
                  <c:pt idx="7">
                    <c:v>8.9975470703582E-2</c:v>
                  </c:pt>
                  <c:pt idx="8">
                    <c:v>4.6984403413567001E-2</c:v>
                  </c:pt>
                  <c:pt idx="9">
                    <c:v>3.22633056082871E-2</c:v>
                  </c:pt>
                  <c:pt idx="10">
                    <c:v>2.7555020765347899E-2</c:v>
                  </c:pt>
                  <c:pt idx="11">
                    <c:v>3.62046567110033E-2</c:v>
                  </c:pt>
                  <c:pt idx="12">
                    <c:v>3.6426177380699698E-2</c:v>
                  </c:pt>
                  <c:pt idx="13">
                    <c:v>6.6750460364472006E-2</c:v>
                  </c:pt>
                  <c:pt idx="14">
                    <c:v>6.6754709167578405E-2</c:v>
                  </c:pt>
                  <c:pt idx="15">
                    <c:v>4.2666556580279999E-2</c:v>
                  </c:pt>
                  <c:pt idx="16">
                    <c:v>6.3798245469879999E-2</c:v>
                  </c:pt>
                  <c:pt idx="17">
                    <c:v>5.5907329376621101E-2</c:v>
                  </c:pt>
                  <c:pt idx="18">
                    <c:v>5.1878868416939998E-2</c:v>
                  </c:pt>
                </c:numCache>
              </c:numRef>
            </c:plus>
            <c:minus>
              <c:numRef>
                <c:f>FINAL_DECOMP_MMPBSA!$S$10:$S$28</c:f>
                <c:numCache>
                  <c:formatCode>General</c:formatCode>
                  <c:ptCount val="19"/>
                  <c:pt idx="0">
                    <c:v>3.5999104207916001E-2</c:v>
                  </c:pt>
                  <c:pt idx="1">
                    <c:v>4.3045387292708702E-2</c:v>
                  </c:pt>
                  <c:pt idx="2">
                    <c:v>3.2423512188104998E-2</c:v>
                  </c:pt>
                  <c:pt idx="3">
                    <c:v>4.2366827809697097E-2</c:v>
                  </c:pt>
                  <c:pt idx="4">
                    <c:v>5.5660128902759301E-2</c:v>
                  </c:pt>
                  <c:pt idx="5">
                    <c:v>7.7669307671570001E-2</c:v>
                  </c:pt>
                  <c:pt idx="6">
                    <c:v>3.2625058349261001E-2</c:v>
                  </c:pt>
                  <c:pt idx="7">
                    <c:v>8.9975470703582E-2</c:v>
                  </c:pt>
                  <c:pt idx="8">
                    <c:v>4.6984403413567001E-2</c:v>
                  </c:pt>
                  <c:pt idx="9">
                    <c:v>3.22633056082871E-2</c:v>
                  </c:pt>
                  <c:pt idx="10">
                    <c:v>2.7555020765347899E-2</c:v>
                  </c:pt>
                  <c:pt idx="11">
                    <c:v>3.62046567110033E-2</c:v>
                  </c:pt>
                  <c:pt idx="12">
                    <c:v>3.6426177380699698E-2</c:v>
                  </c:pt>
                  <c:pt idx="13">
                    <c:v>6.6750460364472006E-2</c:v>
                  </c:pt>
                  <c:pt idx="14">
                    <c:v>6.6754709167578405E-2</c:v>
                  </c:pt>
                  <c:pt idx="15">
                    <c:v>4.2666556580279999E-2</c:v>
                  </c:pt>
                  <c:pt idx="16">
                    <c:v>6.3798245469879999E-2</c:v>
                  </c:pt>
                  <c:pt idx="17">
                    <c:v>5.5907329376621101E-2</c:v>
                  </c:pt>
                  <c:pt idx="18">
                    <c:v>5.1878868416939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_DECOMP_MMPBSA!$A$10:$A$28</c:f>
              <c:strCache>
                <c:ptCount val="19"/>
                <c:pt idx="0">
                  <c:v>R:A:ARG:297</c:v>
                </c:pt>
                <c:pt idx="1">
                  <c:v>R:A:TYR:298</c:v>
                </c:pt>
                <c:pt idx="2">
                  <c:v>R:A:PRO:299</c:v>
                </c:pt>
                <c:pt idx="3">
                  <c:v>R:A:ASN:312</c:v>
                </c:pt>
                <c:pt idx="4">
                  <c:v>R:A:TYR:313</c:v>
                </c:pt>
                <c:pt idx="5">
                  <c:v>R:A:ARG:316</c:v>
                </c:pt>
                <c:pt idx="6">
                  <c:v>R:A:ILE:343</c:v>
                </c:pt>
                <c:pt idx="7">
                  <c:v>R:A:ASP:345</c:v>
                </c:pt>
                <c:pt idx="8">
                  <c:v>R:A:ASP:346</c:v>
                </c:pt>
                <c:pt idx="9">
                  <c:v>R:A:PRO:377</c:v>
                </c:pt>
                <c:pt idx="10">
                  <c:v>R:A:LEU:378</c:v>
                </c:pt>
                <c:pt idx="11">
                  <c:v>R:A:LEU:379</c:v>
                </c:pt>
                <c:pt idx="12">
                  <c:v>R:A:GLY:381</c:v>
                </c:pt>
                <c:pt idx="13">
                  <c:v>R:A:ASP:382</c:v>
                </c:pt>
                <c:pt idx="14">
                  <c:v>R:A:GLU:384</c:v>
                </c:pt>
                <c:pt idx="15">
                  <c:v>R:A:ARG:452</c:v>
                </c:pt>
                <c:pt idx="16">
                  <c:v>R:A:SER:453</c:v>
                </c:pt>
                <c:pt idx="17">
                  <c:v>R:A:PHE:454</c:v>
                </c:pt>
                <c:pt idx="18">
                  <c:v>R:A:THR:455</c:v>
                </c:pt>
              </c:strCache>
            </c:strRef>
          </c:cat>
          <c:val>
            <c:numRef>
              <c:f>FINAL_DECOMP_MMPBSA!$Q$10:$Q$28</c:f>
              <c:numCache>
                <c:formatCode>General</c:formatCode>
                <c:ptCount val="19"/>
                <c:pt idx="0">
                  <c:v>-0.485347476</c:v>
                </c:pt>
                <c:pt idx="1">
                  <c:v>-1.356678072</c:v>
                </c:pt>
                <c:pt idx="2">
                  <c:v>-0.401026416</c:v>
                </c:pt>
                <c:pt idx="3">
                  <c:v>-1.36080409199999</c:v>
                </c:pt>
                <c:pt idx="4">
                  <c:v>-0.66754061200000003</c:v>
                </c:pt>
                <c:pt idx="5">
                  <c:v>-0.145329451999998</c:v>
                </c:pt>
                <c:pt idx="6">
                  <c:v>-6.7669539999999903E-2</c:v>
                </c:pt>
                <c:pt idx="7">
                  <c:v>2.9924060000001099E-2</c:v>
                </c:pt>
                <c:pt idx="8">
                  <c:v>1.3089712000000401E-2</c:v>
                </c:pt>
                <c:pt idx="9">
                  <c:v>-2.8224271999999901E-2</c:v>
                </c:pt>
                <c:pt idx="10">
                  <c:v>-1.02437999999999E-2</c:v>
                </c:pt>
                <c:pt idx="11">
                  <c:v>3.4499999999999301E-3</c:v>
                </c:pt>
                <c:pt idx="12">
                  <c:v>-0.223380263999999</c:v>
                </c:pt>
                <c:pt idx="13">
                  <c:v>3.0282747999998701E-2</c:v>
                </c:pt>
                <c:pt idx="14">
                  <c:v>-0.117629791999999</c:v>
                </c:pt>
                <c:pt idx="15">
                  <c:v>3.5548795999999799E-2</c:v>
                </c:pt>
                <c:pt idx="16">
                  <c:v>6.7669539999999903E-2</c:v>
                </c:pt>
                <c:pt idx="17">
                  <c:v>-2.0371271999999701E-2</c:v>
                </c:pt>
                <c:pt idx="18">
                  <c:v>2.45831519999996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72-4D11-8865-0B431A1324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72739104"/>
        <c:axId val="1572743424"/>
      </c:barChart>
      <c:catAx>
        <c:axId val="15727391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6350" cap="flat" cmpd="sng" algn="ctr">
            <a:solidFill>
              <a:srgbClr val="666699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2743424"/>
        <c:crosses val="autoZero"/>
        <c:auto val="1"/>
        <c:lblAlgn val="ctr"/>
        <c:lblOffset val="100"/>
        <c:noMultiLvlLbl val="0"/>
      </c:catAx>
      <c:valAx>
        <c:axId val="1572743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1" i="0" u="none" strike="noStrike" kern="12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8789194703991773E-2"/>
              <c:y val="0.125952345778021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2739104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36815056044827"/>
          <c:y val="5.0989619996865847E-2"/>
          <c:w val="0.81630755125840593"/>
          <c:h val="0.63479900403708245"/>
        </c:manualLayout>
      </c:layout>
      <c:scatterChart>
        <c:scatterStyle val="lineMarker"/>
        <c:varyColors val="0"/>
        <c:ser>
          <c:idx val="0"/>
          <c:order val="0"/>
          <c:spPr>
            <a:ln w="12700" cap="rnd">
              <a:solidFill>
                <a:srgbClr val="990033"/>
              </a:solidFill>
              <a:round/>
            </a:ln>
            <a:effectLst/>
          </c:spPr>
          <c:marker>
            <c:symbol val="none"/>
          </c:marker>
          <c:xVal>
            <c:numRef>
              <c:f>FINAL_RESULTS_MMPBSA!$A$613:$A$812</c:f>
              <c:numCache>
                <c:formatCode>General</c:formatCode>
                <c:ptCount val="200"/>
                <c:pt idx="0">
                  <c:v>1</c:v>
                </c:pt>
                <c:pt idx="1">
                  <c:v>101</c:v>
                </c:pt>
                <c:pt idx="2">
                  <c:v>201</c:v>
                </c:pt>
                <c:pt idx="3">
                  <c:v>301</c:v>
                </c:pt>
                <c:pt idx="4">
                  <c:v>401</c:v>
                </c:pt>
                <c:pt idx="5">
                  <c:v>501</c:v>
                </c:pt>
                <c:pt idx="6">
                  <c:v>601</c:v>
                </c:pt>
                <c:pt idx="7">
                  <c:v>701</c:v>
                </c:pt>
                <c:pt idx="8">
                  <c:v>801</c:v>
                </c:pt>
                <c:pt idx="9">
                  <c:v>901</c:v>
                </c:pt>
                <c:pt idx="10">
                  <c:v>1001</c:v>
                </c:pt>
                <c:pt idx="11">
                  <c:v>1101</c:v>
                </c:pt>
                <c:pt idx="12">
                  <c:v>1201</c:v>
                </c:pt>
                <c:pt idx="13">
                  <c:v>1301</c:v>
                </c:pt>
                <c:pt idx="14">
                  <c:v>1401</c:v>
                </c:pt>
                <c:pt idx="15">
                  <c:v>1501</c:v>
                </c:pt>
                <c:pt idx="16">
                  <c:v>1601</c:v>
                </c:pt>
                <c:pt idx="17">
                  <c:v>1701</c:v>
                </c:pt>
                <c:pt idx="18">
                  <c:v>1801</c:v>
                </c:pt>
                <c:pt idx="19">
                  <c:v>1901</c:v>
                </c:pt>
                <c:pt idx="20">
                  <c:v>2001</c:v>
                </c:pt>
                <c:pt idx="21">
                  <c:v>2101</c:v>
                </c:pt>
                <c:pt idx="22">
                  <c:v>2201</c:v>
                </c:pt>
                <c:pt idx="23">
                  <c:v>2301</c:v>
                </c:pt>
                <c:pt idx="24">
                  <c:v>2401</c:v>
                </c:pt>
                <c:pt idx="25">
                  <c:v>2501</c:v>
                </c:pt>
                <c:pt idx="26">
                  <c:v>2601</c:v>
                </c:pt>
                <c:pt idx="27">
                  <c:v>2701</c:v>
                </c:pt>
                <c:pt idx="28">
                  <c:v>2801</c:v>
                </c:pt>
                <c:pt idx="29">
                  <c:v>2901</c:v>
                </c:pt>
                <c:pt idx="30">
                  <c:v>3001</c:v>
                </c:pt>
                <c:pt idx="31">
                  <c:v>3101</c:v>
                </c:pt>
                <c:pt idx="32">
                  <c:v>3201</c:v>
                </c:pt>
                <c:pt idx="33">
                  <c:v>3301</c:v>
                </c:pt>
                <c:pt idx="34">
                  <c:v>3401</c:v>
                </c:pt>
                <c:pt idx="35">
                  <c:v>3501</c:v>
                </c:pt>
                <c:pt idx="36">
                  <c:v>3601</c:v>
                </c:pt>
                <c:pt idx="37">
                  <c:v>3701</c:v>
                </c:pt>
                <c:pt idx="38">
                  <c:v>3801</c:v>
                </c:pt>
                <c:pt idx="39">
                  <c:v>3901</c:v>
                </c:pt>
                <c:pt idx="40">
                  <c:v>4001</c:v>
                </c:pt>
                <c:pt idx="41">
                  <c:v>4101</c:v>
                </c:pt>
                <c:pt idx="42">
                  <c:v>4201</c:v>
                </c:pt>
                <c:pt idx="43">
                  <c:v>4301</c:v>
                </c:pt>
                <c:pt idx="44">
                  <c:v>4401</c:v>
                </c:pt>
                <c:pt idx="45">
                  <c:v>4501</c:v>
                </c:pt>
                <c:pt idx="46">
                  <c:v>4601</c:v>
                </c:pt>
                <c:pt idx="47">
                  <c:v>4701</c:v>
                </c:pt>
                <c:pt idx="48">
                  <c:v>4801</c:v>
                </c:pt>
                <c:pt idx="49">
                  <c:v>4901</c:v>
                </c:pt>
                <c:pt idx="50">
                  <c:v>5001</c:v>
                </c:pt>
                <c:pt idx="51">
                  <c:v>5101</c:v>
                </c:pt>
                <c:pt idx="52">
                  <c:v>5201</c:v>
                </c:pt>
                <c:pt idx="53">
                  <c:v>5301</c:v>
                </c:pt>
                <c:pt idx="54">
                  <c:v>5401</c:v>
                </c:pt>
                <c:pt idx="55">
                  <c:v>5501</c:v>
                </c:pt>
                <c:pt idx="56">
                  <c:v>5601</c:v>
                </c:pt>
                <c:pt idx="57">
                  <c:v>5701</c:v>
                </c:pt>
                <c:pt idx="58">
                  <c:v>5801</c:v>
                </c:pt>
                <c:pt idx="59">
                  <c:v>5901</c:v>
                </c:pt>
                <c:pt idx="60">
                  <c:v>6001</c:v>
                </c:pt>
                <c:pt idx="61">
                  <c:v>6101</c:v>
                </c:pt>
                <c:pt idx="62">
                  <c:v>6201</c:v>
                </c:pt>
                <c:pt idx="63">
                  <c:v>6301</c:v>
                </c:pt>
                <c:pt idx="64">
                  <c:v>6401</c:v>
                </c:pt>
                <c:pt idx="65">
                  <c:v>6501</c:v>
                </c:pt>
                <c:pt idx="66">
                  <c:v>6601</c:v>
                </c:pt>
                <c:pt idx="67">
                  <c:v>6701</c:v>
                </c:pt>
                <c:pt idx="68">
                  <c:v>6801</c:v>
                </c:pt>
                <c:pt idx="69">
                  <c:v>6901</c:v>
                </c:pt>
                <c:pt idx="70">
                  <c:v>7001</c:v>
                </c:pt>
                <c:pt idx="71">
                  <c:v>7101</c:v>
                </c:pt>
                <c:pt idx="72">
                  <c:v>7201</c:v>
                </c:pt>
                <c:pt idx="73">
                  <c:v>7301</c:v>
                </c:pt>
                <c:pt idx="74">
                  <c:v>7401</c:v>
                </c:pt>
                <c:pt idx="75">
                  <c:v>7501</c:v>
                </c:pt>
                <c:pt idx="76">
                  <c:v>7601</c:v>
                </c:pt>
                <c:pt idx="77">
                  <c:v>7701</c:v>
                </c:pt>
                <c:pt idx="78">
                  <c:v>7801</c:v>
                </c:pt>
                <c:pt idx="79">
                  <c:v>7901</c:v>
                </c:pt>
                <c:pt idx="80">
                  <c:v>8001</c:v>
                </c:pt>
                <c:pt idx="81">
                  <c:v>8101</c:v>
                </c:pt>
                <c:pt idx="82">
                  <c:v>8201</c:v>
                </c:pt>
                <c:pt idx="83">
                  <c:v>8301</c:v>
                </c:pt>
                <c:pt idx="84">
                  <c:v>8401</c:v>
                </c:pt>
                <c:pt idx="85">
                  <c:v>8501</c:v>
                </c:pt>
                <c:pt idx="86">
                  <c:v>8601</c:v>
                </c:pt>
                <c:pt idx="87">
                  <c:v>8701</c:v>
                </c:pt>
                <c:pt idx="88">
                  <c:v>8801</c:v>
                </c:pt>
                <c:pt idx="89">
                  <c:v>8901</c:v>
                </c:pt>
                <c:pt idx="90">
                  <c:v>9001</c:v>
                </c:pt>
                <c:pt idx="91">
                  <c:v>9101</c:v>
                </c:pt>
                <c:pt idx="92">
                  <c:v>9201</c:v>
                </c:pt>
                <c:pt idx="93">
                  <c:v>9301</c:v>
                </c:pt>
                <c:pt idx="94">
                  <c:v>9401</c:v>
                </c:pt>
                <c:pt idx="95">
                  <c:v>9501</c:v>
                </c:pt>
                <c:pt idx="96">
                  <c:v>9601</c:v>
                </c:pt>
                <c:pt idx="97">
                  <c:v>9701</c:v>
                </c:pt>
                <c:pt idx="98">
                  <c:v>9801</c:v>
                </c:pt>
                <c:pt idx="99">
                  <c:v>9901</c:v>
                </c:pt>
                <c:pt idx="100">
                  <c:v>10001</c:v>
                </c:pt>
                <c:pt idx="101">
                  <c:v>10101</c:v>
                </c:pt>
                <c:pt idx="102">
                  <c:v>10201</c:v>
                </c:pt>
                <c:pt idx="103">
                  <c:v>10301</c:v>
                </c:pt>
                <c:pt idx="104">
                  <c:v>10401</c:v>
                </c:pt>
                <c:pt idx="105">
                  <c:v>10501</c:v>
                </c:pt>
                <c:pt idx="106">
                  <c:v>10601</c:v>
                </c:pt>
                <c:pt idx="107">
                  <c:v>10701</c:v>
                </c:pt>
                <c:pt idx="108">
                  <c:v>10801</c:v>
                </c:pt>
                <c:pt idx="109">
                  <c:v>10901</c:v>
                </c:pt>
                <c:pt idx="110">
                  <c:v>11001</c:v>
                </c:pt>
                <c:pt idx="111">
                  <c:v>11101</c:v>
                </c:pt>
                <c:pt idx="112">
                  <c:v>11201</c:v>
                </c:pt>
                <c:pt idx="113">
                  <c:v>11301</c:v>
                </c:pt>
                <c:pt idx="114">
                  <c:v>11401</c:v>
                </c:pt>
                <c:pt idx="115">
                  <c:v>11501</c:v>
                </c:pt>
                <c:pt idx="116">
                  <c:v>11601</c:v>
                </c:pt>
                <c:pt idx="117">
                  <c:v>11701</c:v>
                </c:pt>
                <c:pt idx="118">
                  <c:v>11801</c:v>
                </c:pt>
                <c:pt idx="119">
                  <c:v>11901</c:v>
                </c:pt>
                <c:pt idx="120">
                  <c:v>12001</c:v>
                </c:pt>
                <c:pt idx="121">
                  <c:v>12101</c:v>
                </c:pt>
                <c:pt idx="122">
                  <c:v>12201</c:v>
                </c:pt>
                <c:pt idx="123">
                  <c:v>12301</c:v>
                </c:pt>
                <c:pt idx="124">
                  <c:v>12401</c:v>
                </c:pt>
                <c:pt idx="125">
                  <c:v>12501</c:v>
                </c:pt>
                <c:pt idx="126">
                  <c:v>12601</c:v>
                </c:pt>
                <c:pt idx="127">
                  <c:v>12701</c:v>
                </c:pt>
                <c:pt idx="128">
                  <c:v>12801</c:v>
                </c:pt>
                <c:pt idx="129">
                  <c:v>12901</c:v>
                </c:pt>
                <c:pt idx="130">
                  <c:v>13001</c:v>
                </c:pt>
                <c:pt idx="131">
                  <c:v>13101</c:v>
                </c:pt>
                <c:pt idx="132">
                  <c:v>13201</c:v>
                </c:pt>
                <c:pt idx="133">
                  <c:v>13301</c:v>
                </c:pt>
                <c:pt idx="134">
                  <c:v>13401</c:v>
                </c:pt>
                <c:pt idx="135">
                  <c:v>13501</c:v>
                </c:pt>
                <c:pt idx="136">
                  <c:v>13601</c:v>
                </c:pt>
                <c:pt idx="137">
                  <c:v>13701</c:v>
                </c:pt>
                <c:pt idx="138">
                  <c:v>13801</c:v>
                </c:pt>
                <c:pt idx="139">
                  <c:v>13901</c:v>
                </c:pt>
                <c:pt idx="140">
                  <c:v>14001</c:v>
                </c:pt>
                <c:pt idx="141">
                  <c:v>14101</c:v>
                </c:pt>
                <c:pt idx="142">
                  <c:v>14201</c:v>
                </c:pt>
                <c:pt idx="143">
                  <c:v>14301</c:v>
                </c:pt>
                <c:pt idx="144">
                  <c:v>14401</c:v>
                </c:pt>
                <c:pt idx="145">
                  <c:v>14501</c:v>
                </c:pt>
                <c:pt idx="146">
                  <c:v>14601</c:v>
                </c:pt>
                <c:pt idx="147">
                  <c:v>14701</c:v>
                </c:pt>
                <c:pt idx="148">
                  <c:v>14801</c:v>
                </c:pt>
                <c:pt idx="149">
                  <c:v>14901</c:v>
                </c:pt>
                <c:pt idx="150">
                  <c:v>15001</c:v>
                </c:pt>
                <c:pt idx="151">
                  <c:v>15101</c:v>
                </c:pt>
                <c:pt idx="152">
                  <c:v>15201</c:v>
                </c:pt>
                <c:pt idx="153">
                  <c:v>15301</c:v>
                </c:pt>
                <c:pt idx="154">
                  <c:v>15401</c:v>
                </c:pt>
                <c:pt idx="155">
                  <c:v>15501</c:v>
                </c:pt>
                <c:pt idx="156">
                  <c:v>15601</c:v>
                </c:pt>
                <c:pt idx="157">
                  <c:v>15701</c:v>
                </c:pt>
                <c:pt idx="158">
                  <c:v>15801</c:v>
                </c:pt>
                <c:pt idx="159">
                  <c:v>15901</c:v>
                </c:pt>
                <c:pt idx="160">
                  <c:v>16001</c:v>
                </c:pt>
                <c:pt idx="161">
                  <c:v>16101</c:v>
                </c:pt>
                <c:pt idx="162">
                  <c:v>16201</c:v>
                </c:pt>
                <c:pt idx="163">
                  <c:v>16301</c:v>
                </c:pt>
                <c:pt idx="164">
                  <c:v>16401</c:v>
                </c:pt>
                <c:pt idx="165">
                  <c:v>16501</c:v>
                </c:pt>
                <c:pt idx="166">
                  <c:v>16601</c:v>
                </c:pt>
                <c:pt idx="167">
                  <c:v>16701</c:v>
                </c:pt>
                <c:pt idx="168">
                  <c:v>16801</c:v>
                </c:pt>
                <c:pt idx="169">
                  <c:v>16901</c:v>
                </c:pt>
                <c:pt idx="170">
                  <c:v>17001</c:v>
                </c:pt>
                <c:pt idx="171">
                  <c:v>17101</c:v>
                </c:pt>
                <c:pt idx="172">
                  <c:v>17201</c:v>
                </c:pt>
                <c:pt idx="173">
                  <c:v>17301</c:v>
                </c:pt>
                <c:pt idx="174">
                  <c:v>17401</c:v>
                </c:pt>
                <c:pt idx="175">
                  <c:v>17501</c:v>
                </c:pt>
                <c:pt idx="176">
                  <c:v>17601</c:v>
                </c:pt>
                <c:pt idx="177">
                  <c:v>17701</c:v>
                </c:pt>
                <c:pt idx="178">
                  <c:v>17801</c:v>
                </c:pt>
                <c:pt idx="179">
                  <c:v>17901</c:v>
                </c:pt>
                <c:pt idx="180">
                  <c:v>18001</c:v>
                </c:pt>
                <c:pt idx="181">
                  <c:v>18101</c:v>
                </c:pt>
                <c:pt idx="182">
                  <c:v>18201</c:v>
                </c:pt>
                <c:pt idx="183">
                  <c:v>18301</c:v>
                </c:pt>
                <c:pt idx="184">
                  <c:v>18401</c:v>
                </c:pt>
                <c:pt idx="185">
                  <c:v>18501</c:v>
                </c:pt>
                <c:pt idx="186">
                  <c:v>18601</c:v>
                </c:pt>
                <c:pt idx="187">
                  <c:v>18701</c:v>
                </c:pt>
                <c:pt idx="188">
                  <c:v>18801</c:v>
                </c:pt>
                <c:pt idx="189">
                  <c:v>18901</c:v>
                </c:pt>
                <c:pt idx="190">
                  <c:v>19001</c:v>
                </c:pt>
                <c:pt idx="191">
                  <c:v>19101</c:v>
                </c:pt>
                <c:pt idx="192">
                  <c:v>19201</c:v>
                </c:pt>
                <c:pt idx="193">
                  <c:v>19301</c:v>
                </c:pt>
                <c:pt idx="194">
                  <c:v>19401</c:v>
                </c:pt>
                <c:pt idx="195">
                  <c:v>19501</c:v>
                </c:pt>
                <c:pt idx="196">
                  <c:v>19601</c:v>
                </c:pt>
                <c:pt idx="197">
                  <c:v>19701</c:v>
                </c:pt>
                <c:pt idx="198">
                  <c:v>19801</c:v>
                </c:pt>
                <c:pt idx="199">
                  <c:v>19901</c:v>
                </c:pt>
              </c:numCache>
            </c:numRef>
          </c:xVal>
          <c:yVal>
            <c:numRef>
              <c:f>FINAL_RESULTS_MMPBSA!$P$613:$P$812</c:f>
              <c:numCache>
                <c:formatCode>General</c:formatCode>
                <c:ptCount val="200"/>
                <c:pt idx="0">
                  <c:v>-12.27</c:v>
                </c:pt>
                <c:pt idx="1">
                  <c:v>-8.84</c:v>
                </c:pt>
                <c:pt idx="2">
                  <c:v>-6.97</c:v>
                </c:pt>
                <c:pt idx="3">
                  <c:v>-12.89</c:v>
                </c:pt>
                <c:pt idx="4">
                  <c:v>-10.3</c:v>
                </c:pt>
                <c:pt idx="5">
                  <c:v>-10.08</c:v>
                </c:pt>
                <c:pt idx="6">
                  <c:v>-7.7</c:v>
                </c:pt>
                <c:pt idx="7">
                  <c:v>-2.81</c:v>
                </c:pt>
                <c:pt idx="8">
                  <c:v>-13.79</c:v>
                </c:pt>
                <c:pt idx="9">
                  <c:v>-13.83</c:v>
                </c:pt>
                <c:pt idx="10">
                  <c:v>-5.54</c:v>
                </c:pt>
                <c:pt idx="11">
                  <c:v>-4.72</c:v>
                </c:pt>
                <c:pt idx="12">
                  <c:v>-6.38</c:v>
                </c:pt>
                <c:pt idx="13">
                  <c:v>-9.06</c:v>
                </c:pt>
                <c:pt idx="14">
                  <c:v>-0.56000000000000005</c:v>
                </c:pt>
                <c:pt idx="15">
                  <c:v>-7.36</c:v>
                </c:pt>
                <c:pt idx="16">
                  <c:v>-7.05</c:v>
                </c:pt>
                <c:pt idx="17">
                  <c:v>0.27</c:v>
                </c:pt>
                <c:pt idx="18">
                  <c:v>-2.31</c:v>
                </c:pt>
                <c:pt idx="19">
                  <c:v>-7.68</c:v>
                </c:pt>
                <c:pt idx="20">
                  <c:v>-8.23</c:v>
                </c:pt>
                <c:pt idx="21">
                  <c:v>-3</c:v>
                </c:pt>
                <c:pt idx="22">
                  <c:v>-8.39</c:v>
                </c:pt>
                <c:pt idx="23">
                  <c:v>-7.64</c:v>
                </c:pt>
                <c:pt idx="24">
                  <c:v>-9.89</c:v>
                </c:pt>
                <c:pt idx="25">
                  <c:v>-8.1199999999999992</c:v>
                </c:pt>
                <c:pt idx="26">
                  <c:v>-7.86</c:v>
                </c:pt>
                <c:pt idx="27">
                  <c:v>-6.31</c:v>
                </c:pt>
                <c:pt idx="28">
                  <c:v>-10.52</c:v>
                </c:pt>
                <c:pt idx="29">
                  <c:v>-8.1</c:v>
                </c:pt>
                <c:pt idx="30">
                  <c:v>-10.68</c:v>
                </c:pt>
                <c:pt idx="31">
                  <c:v>-7.74</c:v>
                </c:pt>
                <c:pt idx="32">
                  <c:v>-10.11</c:v>
                </c:pt>
                <c:pt idx="33">
                  <c:v>-6.51</c:v>
                </c:pt>
                <c:pt idx="34">
                  <c:v>-5.98</c:v>
                </c:pt>
                <c:pt idx="35">
                  <c:v>-6.31</c:v>
                </c:pt>
                <c:pt idx="36">
                  <c:v>-7.29</c:v>
                </c:pt>
                <c:pt idx="37">
                  <c:v>-7.06</c:v>
                </c:pt>
                <c:pt idx="38">
                  <c:v>-9.73</c:v>
                </c:pt>
                <c:pt idx="39">
                  <c:v>-10.64</c:v>
                </c:pt>
                <c:pt idx="40">
                  <c:v>-9.73</c:v>
                </c:pt>
                <c:pt idx="41">
                  <c:v>-11.45</c:v>
                </c:pt>
                <c:pt idx="42">
                  <c:v>-10.3</c:v>
                </c:pt>
                <c:pt idx="43">
                  <c:v>-19.46</c:v>
                </c:pt>
                <c:pt idx="44">
                  <c:v>-21.3</c:v>
                </c:pt>
                <c:pt idx="45">
                  <c:v>-16.940000000000001</c:v>
                </c:pt>
                <c:pt idx="46">
                  <c:v>-20.07</c:v>
                </c:pt>
                <c:pt idx="47">
                  <c:v>-19.850000000000001</c:v>
                </c:pt>
                <c:pt idx="48">
                  <c:v>-22.46</c:v>
                </c:pt>
                <c:pt idx="49">
                  <c:v>-18.75</c:v>
                </c:pt>
                <c:pt idx="50">
                  <c:v>-17.09</c:v>
                </c:pt>
                <c:pt idx="51">
                  <c:v>-20.53</c:v>
                </c:pt>
                <c:pt idx="52">
                  <c:v>-21.9</c:v>
                </c:pt>
                <c:pt idx="53">
                  <c:v>-15.7</c:v>
                </c:pt>
                <c:pt idx="54">
                  <c:v>-12.12</c:v>
                </c:pt>
                <c:pt idx="55">
                  <c:v>-7.71</c:v>
                </c:pt>
                <c:pt idx="56">
                  <c:v>-11.21</c:v>
                </c:pt>
                <c:pt idx="57">
                  <c:v>-13.69</c:v>
                </c:pt>
                <c:pt idx="58">
                  <c:v>-6.58</c:v>
                </c:pt>
                <c:pt idx="59">
                  <c:v>-13.63</c:v>
                </c:pt>
                <c:pt idx="60">
                  <c:v>-11.64</c:v>
                </c:pt>
                <c:pt idx="61">
                  <c:v>-16.170000000000002</c:v>
                </c:pt>
                <c:pt idx="62">
                  <c:v>-6.87</c:v>
                </c:pt>
                <c:pt idx="63">
                  <c:v>-12.82</c:v>
                </c:pt>
                <c:pt idx="64">
                  <c:v>-11.95</c:v>
                </c:pt>
                <c:pt idx="65">
                  <c:v>-13.55</c:v>
                </c:pt>
                <c:pt idx="66">
                  <c:v>-11.27</c:v>
                </c:pt>
                <c:pt idx="67">
                  <c:v>-12.79</c:v>
                </c:pt>
                <c:pt idx="68">
                  <c:v>-14.71</c:v>
                </c:pt>
                <c:pt idx="69">
                  <c:v>-18.23</c:v>
                </c:pt>
                <c:pt idx="70">
                  <c:v>-15.26</c:v>
                </c:pt>
                <c:pt idx="71">
                  <c:v>-16.91</c:v>
                </c:pt>
                <c:pt idx="72">
                  <c:v>-16.86</c:v>
                </c:pt>
                <c:pt idx="73">
                  <c:v>-11.6</c:v>
                </c:pt>
                <c:pt idx="74">
                  <c:v>-15.06</c:v>
                </c:pt>
                <c:pt idx="75">
                  <c:v>-13.28</c:v>
                </c:pt>
                <c:pt idx="76">
                  <c:v>-9.5399999999999991</c:v>
                </c:pt>
                <c:pt idx="77">
                  <c:v>-13.33</c:v>
                </c:pt>
                <c:pt idx="78">
                  <c:v>-13.91</c:v>
                </c:pt>
                <c:pt idx="79">
                  <c:v>-15.22</c:v>
                </c:pt>
                <c:pt idx="80">
                  <c:v>-11.48</c:v>
                </c:pt>
                <c:pt idx="81">
                  <c:v>-15.97</c:v>
                </c:pt>
                <c:pt idx="82">
                  <c:v>-12.45</c:v>
                </c:pt>
                <c:pt idx="83">
                  <c:v>-15.64</c:v>
                </c:pt>
                <c:pt idx="84">
                  <c:v>-12.74</c:v>
                </c:pt>
                <c:pt idx="85">
                  <c:v>-17.03</c:v>
                </c:pt>
                <c:pt idx="86">
                  <c:v>-13.72</c:v>
                </c:pt>
                <c:pt idx="87">
                  <c:v>-11.78</c:v>
                </c:pt>
                <c:pt idx="88">
                  <c:v>-13.98</c:v>
                </c:pt>
                <c:pt idx="89">
                  <c:v>-15.1</c:v>
                </c:pt>
                <c:pt idx="90">
                  <c:v>-14.81</c:v>
                </c:pt>
                <c:pt idx="91">
                  <c:v>-13.73</c:v>
                </c:pt>
                <c:pt idx="92">
                  <c:v>-14.38</c:v>
                </c:pt>
                <c:pt idx="93">
                  <c:v>-16.07</c:v>
                </c:pt>
                <c:pt idx="94">
                  <c:v>-10.77</c:v>
                </c:pt>
                <c:pt idx="95">
                  <c:v>-9.7799999999999994</c:v>
                </c:pt>
                <c:pt idx="96">
                  <c:v>-10.199999999999999</c:v>
                </c:pt>
                <c:pt idx="97">
                  <c:v>-10.41</c:v>
                </c:pt>
                <c:pt idx="98">
                  <c:v>-15.78</c:v>
                </c:pt>
                <c:pt idx="99">
                  <c:v>-10.34</c:v>
                </c:pt>
                <c:pt idx="100">
                  <c:v>-8.44</c:v>
                </c:pt>
                <c:pt idx="101">
                  <c:v>-13.05</c:v>
                </c:pt>
                <c:pt idx="102">
                  <c:v>-14.98</c:v>
                </c:pt>
                <c:pt idx="103">
                  <c:v>-15.47</c:v>
                </c:pt>
                <c:pt idx="104">
                  <c:v>-17.399999999999999</c:v>
                </c:pt>
                <c:pt idx="105">
                  <c:v>-14.76</c:v>
                </c:pt>
                <c:pt idx="106">
                  <c:v>-12.79</c:v>
                </c:pt>
                <c:pt idx="107">
                  <c:v>-12.89</c:v>
                </c:pt>
                <c:pt idx="108">
                  <c:v>-12.01</c:v>
                </c:pt>
                <c:pt idx="109">
                  <c:v>-12.22</c:v>
                </c:pt>
                <c:pt idx="110">
                  <c:v>-11.8</c:v>
                </c:pt>
                <c:pt idx="111">
                  <c:v>-15.1</c:v>
                </c:pt>
                <c:pt idx="112">
                  <c:v>-14.39</c:v>
                </c:pt>
                <c:pt idx="113">
                  <c:v>-17.649999999999999</c:v>
                </c:pt>
                <c:pt idx="114">
                  <c:v>-13.67</c:v>
                </c:pt>
                <c:pt idx="115">
                  <c:v>-13.96</c:v>
                </c:pt>
                <c:pt idx="116">
                  <c:v>-17.64</c:v>
                </c:pt>
                <c:pt idx="117">
                  <c:v>-15.38</c:v>
                </c:pt>
                <c:pt idx="118">
                  <c:v>-19.100000000000001</c:v>
                </c:pt>
                <c:pt idx="119">
                  <c:v>-17.37</c:v>
                </c:pt>
                <c:pt idx="120">
                  <c:v>-19.48</c:v>
                </c:pt>
                <c:pt idx="121">
                  <c:v>-19.72</c:v>
                </c:pt>
                <c:pt idx="122">
                  <c:v>-12.6</c:v>
                </c:pt>
                <c:pt idx="123">
                  <c:v>-21.15</c:v>
                </c:pt>
                <c:pt idx="124">
                  <c:v>-18.02</c:v>
                </c:pt>
                <c:pt idx="125">
                  <c:v>-20.34</c:v>
                </c:pt>
                <c:pt idx="126">
                  <c:v>-19.3</c:v>
                </c:pt>
                <c:pt idx="127">
                  <c:v>-17.07</c:v>
                </c:pt>
                <c:pt idx="128">
                  <c:v>-18.29</c:v>
                </c:pt>
                <c:pt idx="129">
                  <c:v>-16.22</c:v>
                </c:pt>
                <c:pt idx="130">
                  <c:v>-21.17</c:v>
                </c:pt>
                <c:pt idx="131">
                  <c:v>-19.53</c:v>
                </c:pt>
                <c:pt idx="132">
                  <c:v>-25.46</c:v>
                </c:pt>
                <c:pt idx="133">
                  <c:v>-22.77</c:v>
                </c:pt>
                <c:pt idx="134">
                  <c:v>-21.42</c:v>
                </c:pt>
                <c:pt idx="135">
                  <c:v>-23.15</c:v>
                </c:pt>
                <c:pt idx="136">
                  <c:v>-21.29</c:v>
                </c:pt>
                <c:pt idx="137">
                  <c:v>-23.31</c:v>
                </c:pt>
                <c:pt idx="138">
                  <c:v>-19.329999999999998</c:v>
                </c:pt>
                <c:pt idx="139">
                  <c:v>-20.43</c:v>
                </c:pt>
                <c:pt idx="140">
                  <c:v>-20.51</c:v>
                </c:pt>
                <c:pt idx="141">
                  <c:v>-18.98</c:v>
                </c:pt>
                <c:pt idx="142">
                  <c:v>-24.06</c:v>
                </c:pt>
                <c:pt idx="143">
                  <c:v>-21.7</c:v>
                </c:pt>
                <c:pt idx="144">
                  <c:v>-25</c:v>
                </c:pt>
                <c:pt idx="145">
                  <c:v>-19.899999999999999</c:v>
                </c:pt>
                <c:pt idx="146">
                  <c:v>-19.920000000000002</c:v>
                </c:pt>
                <c:pt idx="147">
                  <c:v>-24.8</c:v>
                </c:pt>
                <c:pt idx="148">
                  <c:v>-19.16</c:v>
                </c:pt>
                <c:pt idx="149">
                  <c:v>-19.02</c:v>
                </c:pt>
                <c:pt idx="150">
                  <c:v>-22.3</c:v>
                </c:pt>
                <c:pt idx="151">
                  <c:v>-25.55</c:v>
                </c:pt>
                <c:pt idx="152">
                  <c:v>-17.28</c:v>
                </c:pt>
                <c:pt idx="153">
                  <c:v>-20.34</c:v>
                </c:pt>
                <c:pt idx="154">
                  <c:v>-19.829999999999998</c:v>
                </c:pt>
                <c:pt idx="155">
                  <c:v>-21.08</c:v>
                </c:pt>
                <c:pt idx="156">
                  <c:v>-22.49</c:v>
                </c:pt>
                <c:pt idx="157">
                  <c:v>-19.96</c:v>
                </c:pt>
                <c:pt idx="158">
                  <c:v>-22.32</c:v>
                </c:pt>
                <c:pt idx="159">
                  <c:v>-17.91</c:v>
                </c:pt>
                <c:pt idx="160">
                  <c:v>-17.82</c:v>
                </c:pt>
                <c:pt idx="161">
                  <c:v>-17.97</c:v>
                </c:pt>
                <c:pt idx="162">
                  <c:v>-18.21</c:v>
                </c:pt>
                <c:pt idx="163">
                  <c:v>-17.75</c:v>
                </c:pt>
                <c:pt idx="164">
                  <c:v>-18.260000000000002</c:v>
                </c:pt>
                <c:pt idx="165">
                  <c:v>-17.98</c:v>
                </c:pt>
                <c:pt idx="166">
                  <c:v>-21.46</c:v>
                </c:pt>
                <c:pt idx="167">
                  <c:v>-17.399999999999999</c:v>
                </c:pt>
                <c:pt idx="168">
                  <c:v>-19.25</c:v>
                </c:pt>
                <c:pt idx="169">
                  <c:v>-13.06</c:v>
                </c:pt>
                <c:pt idx="170">
                  <c:v>-16.22</c:v>
                </c:pt>
                <c:pt idx="171">
                  <c:v>-17.21</c:v>
                </c:pt>
                <c:pt idx="172">
                  <c:v>-19.93</c:v>
                </c:pt>
                <c:pt idx="173">
                  <c:v>-9.09</c:v>
                </c:pt>
                <c:pt idx="174">
                  <c:v>-7.66</c:v>
                </c:pt>
                <c:pt idx="175">
                  <c:v>-8.1999999999999993</c:v>
                </c:pt>
                <c:pt idx="176">
                  <c:v>-7.77</c:v>
                </c:pt>
                <c:pt idx="177">
                  <c:v>-9.1199999999999992</c:v>
                </c:pt>
                <c:pt idx="178">
                  <c:v>-8.11</c:v>
                </c:pt>
                <c:pt idx="179">
                  <c:v>-10.72</c:v>
                </c:pt>
                <c:pt idx="180">
                  <c:v>-13.21</c:v>
                </c:pt>
                <c:pt idx="181">
                  <c:v>-9.1199999999999992</c:v>
                </c:pt>
                <c:pt idx="182">
                  <c:v>-11.49</c:v>
                </c:pt>
                <c:pt idx="183">
                  <c:v>-9.25</c:v>
                </c:pt>
                <c:pt idx="184">
                  <c:v>-11.11</c:v>
                </c:pt>
                <c:pt idx="185">
                  <c:v>-11.36</c:v>
                </c:pt>
                <c:pt idx="186">
                  <c:v>-9.74</c:v>
                </c:pt>
                <c:pt idx="187">
                  <c:v>-11.34</c:v>
                </c:pt>
                <c:pt idx="188">
                  <c:v>-10.71</c:v>
                </c:pt>
                <c:pt idx="189">
                  <c:v>-9.17</c:v>
                </c:pt>
                <c:pt idx="190">
                  <c:v>-9.6</c:v>
                </c:pt>
                <c:pt idx="191">
                  <c:v>-11.37</c:v>
                </c:pt>
                <c:pt idx="192">
                  <c:v>-10.26</c:v>
                </c:pt>
                <c:pt idx="193">
                  <c:v>-12.28</c:v>
                </c:pt>
                <c:pt idx="194">
                  <c:v>-9.8000000000000007</c:v>
                </c:pt>
                <c:pt idx="195">
                  <c:v>-4.3099999999999996</c:v>
                </c:pt>
                <c:pt idx="196">
                  <c:v>-6.73</c:v>
                </c:pt>
                <c:pt idx="197">
                  <c:v>-4.72</c:v>
                </c:pt>
                <c:pt idx="198">
                  <c:v>-5.89</c:v>
                </c:pt>
                <c:pt idx="199">
                  <c:v>-2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DB-4059-B2A9-DAC6B29AA0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7142559"/>
        <c:axId val="867143999"/>
      </c:scatterChart>
      <c:valAx>
        <c:axId val="867142559"/>
        <c:scaling>
          <c:orientation val="minMax"/>
          <c:max val="200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mes</a:t>
                </a:r>
              </a:p>
            </c:rich>
          </c:tx>
          <c:layout>
            <c:manualLayout>
              <c:xMode val="edge"/>
              <c:yMode val="edge"/>
              <c:x val="0.49840277050374565"/>
              <c:y val="0.871217318412130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noFill/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67143999"/>
        <c:crosses val="autoZero"/>
        <c:crossBetween val="midCat"/>
      </c:valAx>
      <c:valAx>
        <c:axId val="86714399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 b="1" i="0" u="none" strike="noStrike" kern="12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1662911786654169E-2"/>
              <c:y val="0.122262656614173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67142559"/>
        <c:crosses val="autoZero"/>
        <c:crossBetween val="midCat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65026576188576"/>
          <c:y val="5.4169897271505403E-2"/>
          <c:w val="0.80601261300021398"/>
          <c:h val="0.757866265806877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666699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NAL_DECOMP_MMPBSA!$S$10:$S$28</c:f>
                <c:numCache>
                  <c:formatCode>General</c:formatCode>
                  <c:ptCount val="19"/>
                  <c:pt idx="0">
                    <c:v>3.4888104207916E-2</c:v>
                  </c:pt>
                  <c:pt idx="1">
                    <c:v>4.4048387292708699E-2</c:v>
                  </c:pt>
                  <c:pt idx="2">
                    <c:v>3.3433512188105002E-2</c:v>
                  </c:pt>
                  <c:pt idx="3">
                    <c:v>4.3346827809697099E-2</c:v>
                  </c:pt>
                  <c:pt idx="4">
                    <c:v>5.1610128902759303E-2</c:v>
                  </c:pt>
                  <c:pt idx="5">
                    <c:v>6.7319307671575998E-2</c:v>
                  </c:pt>
                  <c:pt idx="6">
                    <c:v>3.1615058349260997E-2</c:v>
                  </c:pt>
                  <c:pt idx="7">
                    <c:v>8.8195470703581996E-2</c:v>
                  </c:pt>
                  <c:pt idx="8">
                    <c:v>4.5974403413566997E-2</c:v>
                  </c:pt>
                  <c:pt idx="9">
                    <c:v>3.4273305608287098E-2</c:v>
                  </c:pt>
                  <c:pt idx="10">
                    <c:v>3.4146177380699701E-2</c:v>
                  </c:pt>
                  <c:pt idx="11">
                    <c:v>3.62046567110033E-2</c:v>
                  </c:pt>
                  <c:pt idx="12">
                    <c:v>2.6365020765347899E-2</c:v>
                  </c:pt>
                  <c:pt idx="13">
                    <c:v>5.389824546988E-2</c:v>
                  </c:pt>
                  <c:pt idx="14">
                    <c:v>6.4130460364471994E-2</c:v>
                  </c:pt>
                  <c:pt idx="15">
                    <c:v>4.3655565802808001E-2</c:v>
                  </c:pt>
                  <c:pt idx="16">
                    <c:v>6.7730709167578396E-2</c:v>
                  </c:pt>
                  <c:pt idx="17">
                    <c:v>5.08973293766211E-2</c:v>
                  </c:pt>
                  <c:pt idx="18">
                    <c:v>5.0778868416947003E-2</c:v>
                  </c:pt>
                </c:numCache>
              </c:numRef>
            </c:plus>
            <c:minus>
              <c:numRef>
                <c:f>FINAL_DECOMP_MMPBSA!$S$10:$S$28</c:f>
                <c:numCache>
                  <c:formatCode>General</c:formatCode>
                  <c:ptCount val="19"/>
                  <c:pt idx="0">
                    <c:v>3.4888104207916E-2</c:v>
                  </c:pt>
                  <c:pt idx="1">
                    <c:v>4.4048387292708699E-2</c:v>
                  </c:pt>
                  <c:pt idx="2">
                    <c:v>3.3433512188105002E-2</c:v>
                  </c:pt>
                  <c:pt idx="3">
                    <c:v>4.3346827809697099E-2</c:v>
                  </c:pt>
                  <c:pt idx="4">
                    <c:v>5.1610128902759303E-2</c:v>
                  </c:pt>
                  <c:pt idx="5">
                    <c:v>6.7319307671575998E-2</c:v>
                  </c:pt>
                  <c:pt idx="6">
                    <c:v>3.1615058349260997E-2</c:v>
                  </c:pt>
                  <c:pt idx="7">
                    <c:v>8.8195470703581996E-2</c:v>
                  </c:pt>
                  <c:pt idx="8">
                    <c:v>4.5974403413566997E-2</c:v>
                  </c:pt>
                  <c:pt idx="9">
                    <c:v>3.4273305608287098E-2</c:v>
                  </c:pt>
                  <c:pt idx="10">
                    <c:v>3.4146177380699701E-2</c:v>
                  </c:pt>
                  <c:pt idx="11">
                    <c:v>3.62046567110033E-2</c:v>
                  </c:pt>
                  <c:pt idx="12">
                    <c:v>2.6365020765347899E-2</c:v>
                  </c:pt>
                  <c:pt idx="13">
                    <c:v>5.389824546988E-2</c:v>
                  </c:pt>
                  <c:pt idx="14">
                    <c:v>6.4130460364471994E-2</c:v>
                  </c:pt>
                  <c:pt idx="15">
                    <c:v>4.3655565802808001E-2</c:v>
                  </c:pt>
                  <c:pt idx="16">
                    <c:v>6.7730709167578396E-2</c:v>
                  </c:pt>
                  <c:pt idx="17">
                    <c:v>5.08973293766211E-2</c:v>
                  </c:pt>
                  <c:pt idx="18">
                    <c:v>5.077886841694700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NAL_DECOMP_MMPBSA!$A$10:$A$28</c:f>
              <c:strCache>
                <c:ptCount val="19"/>
                <c:pt idx="0">
                  <c:v>R:A:ARG:297</c:v>
                </c:pt>
                <c:pt idx="1">
                  <c:v>R:A:TYR:298</c:v>
                </c:pt>
                <c:pt idx="2">
                  <c:v>R:A:PRO:299</c:v>
                </c:pt>
                <c:pt idx="3">
                  <c:v>R:A:ASN:312</c:v>
                </c:pt>
                <c:pt idx="4">
                  <c:v>R:A:TYR:313</c:v>
                </c:pt>
                <c:pt idx="5">
                  <c:v>R:A:ARG:316</c:v>
                </c:pt>
                <c:pt idx="6">
                  <c:v>R:A:ILE:343</c:v>
                </c:pt>
                <c:pt idx="7">
                  <c:v>R:A:ASP:345</c:v>
                </c:pt>
                <c:pt idx="8">
                  <c:v>R:A:ASP:346</c:v>
                </c:pt>
                <c:pt idx="9">
                  <c:v>R:A:PRO:377</c:v>
                </c:pt>
                <c:pt idx="10">
                  <c:v>R:A:LEU:378</c:v>
                </c:pt>
                <c:pt idx="11">
                  <c:v>R:A:LEU:379</c:v>
                </c:pt>
                <c:pt idx="12">
                  <c:v>R:A:GLY:381</c:v>
                </c:pt>
                <c:pt idx="13">
                  <c:v>R:A:ASP:382</c:v>
                </c:pt>
                <c:pt idx="14">
                  <c:v>R:A:GLU:384</c:v>
                </c:pt>
                <c:pt idx="15">
                  <c:v>R:A:ARG:452</c:v>
                </c:pt>
                <c:pt idx="16">
                  <c:v>R:A:SER:453</c:v>
                </c:pt>
                <c:pt idx="17">
                  <c:v>R:A:PHE:454</c:v>
                </c:pt>
                <c:pt idx="18">
                  <c:v>R:A:THR:455</c:v>
                </c:pt>
              </c:strCache>
            </c:strRef>
          </c:cat>
          <c:val>
            <c:numRef>
              <c:f>FINAL_DECOMP_MMPBSA!$Q$10:$Q$28</c:f>
              <c:numCache>
                <c:formatCode>General</c:formatCode>
                <c:ptCount val="19"/>
                <c:pt idx="0">
                  <c:v>-0.49524747600000002</c:v>
                </c:pt>
                <c:pt idx="1">
                  <c:v>-1.366738072</c:v>
                </c:pt>
                <c:pt idx="2">
                  <c:v>-0.50101641600000002</c:v>
                </c:pt>
                <c:pt idx="3">
                  <c:v>-1.35060409199999</c:v>
                </c:pt>
                <c:pt idx="4">
                  <c:v>-0.65763061199999995</c:v>
                </c:pt>
                <c:pt idx="5">
                  <c:v>-3.8769451999997998E-2</c:v>
                </c:pt>
                <c:pt idx="6">
                  <c:v>-6.0695399999999202E-3</c:v>
                </c:pt>
                <c:pt idx="7">
                  <c:v>3.9824060000001098E-2</c:v>
                </c:pt>
                <c:pt idx="8">
                  <c:v>2.20897120000004E-2</c:v>
                </c:pt>
                <c:pt idx="9">
                  <c:v>-3.8424271999999898E-2</c:v>
                </c:pt>
                <c:pt idx="10">
                  <c:v>-6.6599999999998102E-3</c:v>
                </c:pt>
                <c:pt idx="11">
                  <c:v>3.4499999999999301E-3</c:v>
                </c:pt>
                <c:pt idx="12">
                  <c:v>-6.7669539999999903E-2</c:v>
                </c:pt>
                <c:pt idx="13">
                  <c:v>6.1802639999996899E-3</c:v>
                </c:pt>
                <c:pt idx="14">
                  <c:v>-5.0882747999998701E-2</c:v>
                </c:pt>
                <c:pt idx="15">
                  <c:v>2.5448795999999801E-2</c:v>
                </c:pt>
                <c:pt idx="16">
                  <c:v>7.0297919999999002E-3</c:v>
                </c:pt>
                <c:pt idx="17">
                  <c:v>-2.2371271999999699E-2</c:v>
                </c:pt>
                <c:pt idx="18">
                  <c:v>3.95831519999996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B6-4E28-940D-97FD0A642C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72774144"/>
        <c:axId val="1572771744"/>
      </c:barChart>
      <c:catAx>
        <c:axId val="15727741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6350" cap="flat" cmpd="sng" algn="ctr">
            <a:solidFill>
              <a:srgbClr val="666699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2771744"/>
        <c:crosses val="autoZero"/>
        <c:auto val="1"/>
        <c:lblAlgn val="ctr"/>
        <c:lblOffset val="100"/>
        <c:noMultiLvlLbl val="0"/>
      </c:catAx>
      <c:valAx>
        <c:axId val="15727717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 b="1" i="0" u="none" strike="noStrike" kern="12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ding Energy (kcal/mol)</a:t>
                </a:r>
              </a:p>
            </c:rich>
          </c:tx>
          <c:layout>
            <c:manualLayout>
              <c:xMode val="edge"/>
              <c:yMode val="edge"/>
              <c:x val="1.8827179763807322E-2"/>
              <c:y val="0.101832536605922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72774144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317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DEAF8F-03FE-44C5-A1AD-6C631D3A4B95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751013" y="1143000"/>
            <a:ext cx="3355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9B757B-A529-4474-AE27-1222163AF7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9094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1pPr>
    <a:lvl2pPr marL="318211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2pPr>
    <a:lvl3pPr marL="636422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3pPr>
    <a:lvl4pPr marL="954634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4pPr>
    <a:lvl5pPr marL="1272845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5pPr>
    <a:lvl6pPr marL="1591056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6pPr>
    <a:lvl7pPr marL="1909267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7pPr>
    <a:lvl8pPr marL="2227478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8pPr>
    <a:lvl9pPr marL="2545690" algn="l" defTabSz="636422" rtl="0" eaLnBrk="1" latinLnBrk="0" hangingPunct="1">
      <a:defRPr sz="83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751013" y="1143000"/>
            <a:ext cx="33559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9B757B-A529-4474-AE27-1222163AF71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032470"/>
            <a:ext cx="5829300" cy="219637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313541"/>
            <a:ext cx="5143500" cy="1523148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211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06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35881"/>
            <a:ext cx="1478756" cy="534635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35881"/>
            <a:ext cx="4350544" cy="534635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494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87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572802"/>
            <a:ext cx="5915025" cy="262425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221882"/>
            <a:ext cx="5915025" cy="1380033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719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679406"/>
            <a:ext cx="2914650" cy="40028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679406"/>
            <a:ext cx="2914650" cy="400282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314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35883"/>
            <a:ext cx="5915025" cy="121939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546514"/>
            <a:ext cx="2901255" cy="757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304437"/>
            <a:ext cx="2901255" cy="33894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546514"/>
            <a:ext cx="2915543" cy="757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304437"/>
            <a:ext cx="2915543" cy="33894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688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024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72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0582"/>
            <a:ext cx="2211884" cy="147203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908341"/>
            <a:ext cx="3471863" cy="448328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92618"/>
            <a:ext cx="2211884" cy="350630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306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0582"/>
            <a:ext cx="2211884" cy="1472036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908341"/>
            <a:ext cx="3471863" cy="448328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1892618"/>
            <a:ext cx="2211884" cy="350630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864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35883"/>
            <a:ext cx="5915025" cy="12193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679406"/>
            <a:ext cx="5915025" cy="40028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5847255"/>
            <a:ext cx="1543050" cy="335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936A2B-986E-45FD-BB8B-E5E0920AE6C6}" type="datetimeFigureOut">
              <a:rPr lang="en-US" smtClean="0"/>
              <a:t>4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5847255"/>
            <a:ext cx="2314575" cy="335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5847255"/>
            <a:ext cx="1543050" cy="335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DFAFE-DDB3-49DF-83E9-50EA27295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598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81" name="Group 580">
            <a:extLst>
              <a:ext uri="{FF2B5EF4-FFF2-40B4-BE49-F238E27FC236}">
                <a16:creationId xmlns:a16="http://schemas.microsoft.com/office/drawing/2014/main" id="{46584E22-7DD1-40E1-22F6-093F6D0A1C32}"/>
              </a:ext>
            </a:extLst>
          </p:cNvPr>
          <p:cNvGrpSpPr/>
          <p:nvPr/>
        </p:nvGrpSpPr>
        <p:grpSpPr>
          <a:xfrm>
            <a:off x="45581" y="20750"/>
            <a:ext cx="6766837" cy="2114754"/>
            <a:chOff x="41765" y="-21794"/>
            <a:chExt cx="6766837" cy="2114754"/>
          </a:xfrm>
        </p:grpSpPr>
        <p:grpSp>
          <p:nvGrpSpPr>
            <p:cNvPr id="582" name="Group 581">
              <a:extLst>
                <a:ext uri="{FF2B5EF4-FFF2-40B4-BE49-F238E27FC236}">
                  <a16:creationId xmlns:a16="http://schemas.microsoft.com/office/drawing/2014/main" id="{928FD7D7-DCE4-79FC-9DA6-3E1012D96FF9}"/>
                </a:ext>
              </a:extLst>
            </p:cNvPr>
            <p:cNvGrpSpPr/>
            <p:nvPr/>
          </p:nvGrpSpPr>
          <p:grpSpPr>
            <a:xfrm>
              <a:off x="585744" y="30480"/>
              <a:ext cx="2661856" cy="1791825"/>
              <a:chOff x="585744" y="30480"/>
              <a:chExt cx="2661856" cy="1791825"/>
            </a:xfrm>
          </p:grpSpPr>
          <p:grpSp>
            <p:nvGrpSpPr>
              <p:cNvPr id="634" name="Group 633">
                <a:extLst>
                  <a:ext uri="{FF2B5EF4-FFF2-40B4-BE49-F238E27FC236}">
                    <a16:creationId xmlns:a16="http://schemas.microsoft.com/office/drawing/2014/main" id="{359B8035-0F01-ECC0-D52B-14E13D90CE74}"/>
                  </a:ext>
                </a:extLst>
              </p:cNvPr>
              <p:cNvGrpSpPr/>
              <p:nvPr/>
            </p:nvGrpSpPr>
            <p:grpSpPr>
              <a:xfrm>
                <a:off x="1374414" y="30480"/>
                <a:ext cx="685800" cy="1791825"/>
                <a:chOff x="4709160" y="67455"/>
                <a:chExt cx="685800" cy="1791825"/>
              </a:xfrm>
            </p:grpSpPr>
            <p:sp>
              <p:nvSpPr>
                <p:cNvPr id="667" name="Rectangle 666">
                  <a:extLst>
                    <a:ext uri="{FF2B5EF4-FFF2-40B4-BE49-F238E27FC236}">
                      <a16:creationId xmlns:a16="http://schemas.microsoft.com/office/drawing/2014/main" id="{58EA6493-D957-885E-8136-70B9FF66E94D}"/>
                    </a:ext>
                  </a:extLst>
                </p:cNvPr>
                <p:cNvSpPr/>
                <p:nvPr/>
              </p:nvSpPr>
              <p:spPr>
                <a:xfrm>
                  <a:off x="4709160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8" name="Rectangle 667">
                  <a:extLst>
                    <a:ext uri="{FF2B5EF4-FFF2-40B4-BE49-F238E27FC236}">
                      <a16:creationId xmlns:a16="http://schemas.microsoft.com/office/drawing/2014/main" id="{C76CD07A-78AB-1AC6-752C-BC94AFB7F6B6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9" name="Rectangle 668">
                  <a:extLst>
                    <a:ext uri="{FF2B5EF4-FFF2-40B4-BE49-F238E27FC236}">
                      <a16:creationId xmlns:a16="http://schemas.microsoft.com/office/drawing/2014/main" id="{3925A131-2F3B-DD5A-A2A5-93604E6E5B8D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0" name="Rectangle 669">
                  <a:extLst>
                    <a:ext uri="{FF2B5EF4-FFF2-40B4-BE49-F238E27FC236}">
                      <a16:creationId xmlns:a16="http://schemas.microsoft.com/office/drawing/2014/main" id="{53C6F2D8-0245-D93F-3960-B955DA6B5FD4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1" name="Rectangle 670">
                  <a:extLst>
                    <a:ext uri="{FF2B5EF4-FFF2-40B4-BE49-F238E27FC236}">
                      <a16:creationId xmlns:a16="http://schemas.microsoft.com/office/drawing/2014/main" id="{156F8E98-80B4-010E-A8A1-E717A47155A5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2" name="Rectangle 671">
                  <a:extLst>
                    <a:ext uri="{FF2B5EF4-FFF2-40B4-BE49-F238E27FC236}">
                      <a16:creationId xmlns:a16="http://schemas.microsoft.com/office/drawing/2014/main" id="{1A01648D-3A37-628B-7C2C-547BDE511958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3" name="Rectangle 672">
                  <a:extLst>
                    <a:ext uri="{FF2B5EF4-FFF2-40B4-BE49-F238E27FC236}">
                      <a16:creationId xmlns:a16="http://schemas.microsoft.com/office/drawing/2014/main" id="{A8C348D4-D0E6-2977-EB66-40402E968360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4" name="Rectangle 673">
                  <a:extLst>
                    <a:ext uri="{FF2B5EF4-FFF2-40B4-BE49-F238E27FC236}">
                      <a16:creationId xmlns:a16="http://schemas.microsoft.com/office/drawing/2014/main" id="{18D1A3EF-6047-5504-309E-2C3C7DEC52E3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5" name="Rectangle 674">
                  <a:extLst>
                    <a:ext uri="{FF2B5EF4-FFF2-40B4-BE49-F238E27FC236}">
                      <a16:creationId xmlns:a16="http://schemas.microsoft.com/office/drawing/2014/main" id="{F4CD45CA-3499-560E-9B5C-B2892374D48E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6" name="Rectangle 675">
                  <a:extLst>
                    <a:ext uri="{FF2B5EF4-FFF2-40B4-BE49-F238E27FC236}">
                      <a16:creationId xmlns:a16="http://schemas.microsoft.com/office/drawing/2014/main" id="{F1D6D588-5270-4FE7-0DF3-F46860BBF1EB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7" name="Rectangle 676">
                  <a:extLst>
                    <a:ext uri="{FF2B5EF4-FFF2-40B4-BE49-F238E27FC236}">
                      <a16:creationId xmlns:a16="http://schemas.microsoft.com/office/drawing/2014/main" id="{DE1CECF3-F94B-7AF4-BA84-1B2FC7CC1A45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8" name="Rectangle 677">
                  <a:extLst>
                    <a:ext uri="{FF2B5EF4-FFF2-40B4-BE49-F238E27FC236}">
                      <a16:creationId xmlns:a16="http://schemas.microsoft.com/office/drawing/2014/main" id="{35C84C26-1527-3E43-4DA5-BD9309F3D555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9" name="Rectangle 678">
                  <a:extLst>
                    <a:ext uri="{FF2B5EF4-FFF2-40B4-BE49-F238E27FC236}">
                      <a16:creationId xmlns:a16="http://schemas.microsoft.com/office/drawing/2014/main" id="{F84BBCC7-CA00-BF70-F68D-0540A1AD34B3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80" name="Rectangle 679">
                  <a:extLst>
                    <a:ext uri="{FF2B5EF4-FFF2-40B4-BE49-F238E27FC236}">
                      <a16:creationId xmlns:a16="http://schemas.microsoft.com/office/drawing/2014/main" id="{EEFE5879-D783-D541-9EFC-FB3C3246A7A7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81" name="Rectangle 680">
                  <a:extLst>
                    <a:ext uri="{FF2B5EF4-FFF2-40B4-BE49-F238E27FC236}">
                      <a16:creationId xmlns:a16="http://schemas.microsoft.com/office/drawing/2014/main" id="{F68419ED-1B6B-4BC6-7AE3-D77CE68FA56A}"/>
                    </a:ext>
                  </a:extLst>
                </p:cNvPr>
                <p:cNvSpPr/>
                <p:nvPr/>
              </p:nvSpPr>
              <p:spPr>
                <a:xfrm>
                  <a:off x="4709160" y="67455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SOLV</a:t>
                  </a:r>
                </a:p>
              </p:txBody>
            </p:sp>
          </p:grpSp>
          <p:grpSp>
            <p:nvGrpSpPr>
              <p:cNvPr id="635" name="Group 634">
                <a:extLst>
                  <a:ext uri="{FF2B5EF4-FFF2-40B4-BE49-F238E27FC236}">
                    <a16:creationId xmlns:a16="http://schemas.microsoft.com/office/drawing/2014/main" id="{76676D6C-A0FD-1B82-4CC2-2139C35823BE}"/>
                  </a:ext>
                </a:extLst>
              </p:cNvPr>
              <p:cNvGrpSpPr/>
              <p:nvPr/>
            </p:nvGrpSpPr>
            <p:grpSpPr>
              <a:xfrm>
                <a:off x="585744" y="30480"/>
                <a:ext cx="685800" cy="1789199"/>
                <a:chOff x="4709160" y="70081"/>
                <a:chExt cx="685800" cy="1789199"/>
              </a:xfrm>
            </p:grpSpPr>
            <p:sp>
              <p:nvSpPr>
                <p:cNvPr id="652" name="Rectangle 651">
                  <a:extLst>
                    <a:ext uri="{FF2B5EF4-FFF2-40B4-BE49-F238E27FC236}">
                      <a16:creationId xmlns:a16="http://schemas.microsoft.com/office/drawing/2014/main" id="{66DE339D-E37F-7149-3978-A4F823C26A94}"/>
                    </a:ext>
                  </a:extLst>
                </p:cNvPr>
                <p:cNvSpPr/>
                <p:nvPr/>
              </p:nvSpPr>
              <p:spPr>
                <a:xfrm>
                  <a:off x="4709160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3" name="Rectangle 652">
                  <a:extLst>
                    <a:ext uri="{FF2B5EF4-FFF2-40B4-BE49-F238E27FC236}">
                      <a16:creationId xmlns:a16="http://schemas.microsoft.com/office/drawing/2014/main" id="{E54D581D-8F8D-83CB-949E-DDBC88A2B82E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4" name="Rectangle 653">
                  <a:extLst>
                    <a:ext uri="{FF2B5EF4-FFF2-40B4-BE49-F238E27FC236}">
                      <a16:creationId xmlns:a16="http://schemas.microsoft.com/office/drawing/2014/main" id="{8602F7B1-0296-9775-84DA-DDBE16A61CD3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5" name="Rectangle 654">
                  <a:extLst>
                    <a:ext uri="{FF2B5EF4-FFF2-40B4-BE49-F238E27FC236}">
                      <a16:creationId xmlns:a16="http://schemas.microsoft.com/office/drawing/2014/main" id="{DA687665-753E-6EBE-E598-01D96C6B9E80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6" name="Rectangle 655">
                  <a:extLst>
                    <a:ext uri="{FF2B5EF4-FFF2-40B4-BE49-F238E27FC236}">
                      <a16:creationId xmlns:a16="http://schemas.microsoft.com/office/drawing/2014/main" id="{0C11F635-18A2-00F8-6538-C31764A10ADD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7" name="Rectangle 656">
                  <a:extLst>
                    <a:ext uri="{FF2B5EF4-FFF2-40B4-BE49-F238E27FC236}">
                      <a16:creationId xmlns:a16="http://schemas.microsoft.com/office/drawing/2014/main" id="{6B3C9313-7135-4D8E-F145-5B38F968C67E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8" name="Rectangle 657">
                  <a:extLst>
                    <a:ext uri="{FF2B5EF4-FFF2-40B4-BE49-F238E27FC236}">
                      <a16:creationId xmlns:a16="http://schemas.microsoft.com/office/drawing/2014/main" id="{8A077C56-40DC-373E-0ADB-A4FDBED978E6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9" name="Rectangle 658">
                  <a:extLst>
                    <a:ext uri="{FF2B5EF4-FFF2-40B4-BE49-F238E27FC236}">
                      <a16:creationId xmlns:a16="http://schemas.microsoft.com/office/drawing/2014/main" id="{1590914F-9096-ADC1-7DB5-3677C518FD7F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0" name="Rectangle 659">
                  <a:extLst>
                    <a:ext uri="{FF2B5EF4-FFF2-40B4-BE49-F238E27FC236}">
                      <a16:creationId xmlns:a16="http://schemas.microsoft.com/office/drawing/2014/main" id="{AE6F2BA1-DBA2-1F59-A47C-D119479D5646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1" name="Rectangle 660">
                  <a:extLst>
                    <a:ext uri="{FF2B5EF4-FFF2-40B4-BE49-F238E27FC236}">
                      <a16:creationId xmlns:a16="http://schemas.microsoft.com/office/drawing/2014/main" id="{31A8D390-F8BB-EB9D-66C1-FF64605A64D4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2" name="Rectangle 661">
                  <a:extLst>
                    <a:ext uri="{FF2B5EF4-FFF2-40B4-BE49-F238E27FC236}">
                      <a16:creationId xmlns:a16="http://schemas.microsoft.com/office/drawing/2014/main" id="{6A97B23A-AB8A-FB56-D365-CE155864DDBD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3" name="Rectangle 662">
                  <a:extLst>
                    <a:ext uri="{FF2B5EF4-FFF2-40B4-BE49-F238E27FC236}">
                      <a16:creationId xmlns:a16="http://schemas.microsoft.com/office/drawing/2014/main" id="{4D9BA78B-7994-6C7C-FF50-27BC7D797C2D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4" name="Rectangle 663">
                  <a:extLst>
                    <a:ext uri="{FF2B5EF4-FFF2-40B4-BE49-F238E27FC236}">
                      <a16:creationId xmlns:a16="http://schemas.microsoft.com/office/drawing/2014/main" id="{70EC5052-C874-5578-D898-F779C047413F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5" name="Rectangle 664">
                  <a:extLst>
                    <a:ext uri="{FF2B5EF4-FFF2-40B4-BE49-F238E27FC236}">
                      <a16:creationId xmlns:a16="http://schemas.microsoft.com/office/drawing/2014/main" id="{74040A13-B18C-81EC-A5F7-55D386E046DD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66" name="Rectangle 665">
                  <a:extLst>
                    <a:ext uri="{FF2B5EF4-FFF2-40B4-BE49-F238E27FC236}">
                      <a16:creationId xmlns:a16="http://schemas.microsoft.com/office/drawing/2014/main" id="{D7528151-BD60-9367-CE42-EC71EAADB0E7}"/>
                    </a:ext>
                  </a:extLst>
                </p:cNvPr>
                <p:cNvSpPr/>
                <p:nvPr/>
              </p:nvSpPr>
              <p:spPr>
                <a:xfrm>
                  <a:off x="4709160" y="70081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GAS</a:t>
                  </a:r>
                </a:p>
              </p:txBody>
            </p:sp>
          </p:grpSp>
          <p:grpSp>
            <p:nvGrpSpPr>
              <p:cNvPr id="636" name="Group 635">
                <a:extLst>
                  <a:ext uri="{FF2B5EF4-FFF2-40B4-BE49-F238E27FC236}">
                    <a16:creationId xmlns:a16="http://schemas.microsoft.com/office/drawing/2014/main" id="{9300EBD2-FAD6-FD46-1C77-00C7CA066D55}"/>
                  </a:ext>
                </a:extLst>
              </p:cNvPr>
              <p:cNvGrpSpPr/>
              <p:nvPr/>
            </p:nvGrpSpPr>
            <p:grpSpPr>
              <a:xfrm>
                <a:off x="2163074" y="30480"/>
                <a:ext cx="1084526" cy="1789199"/>
                <a:chOff x="4709158" y="70081"/>
                <a:chExt cx="685802" cy="1789199"/>
              </a:xfrm>
            </p:grpSpPr>
            <p:sp>
              <p:nvSpPr>
                <p:cNvPr id="637" name="Rectangle 636">
                  <a:extLst>
                    <a:ext uri="{FF2B5EF4-FFF2-40B4-BE49-F238E27FC236}">
                      <a16:creationId xmlns:a16="http://schemas.microsoft.com/office/drawing/2014/main" id="{EB5E841B-E87F-0F19-6D7E-2C627CC21B97}"/>
                    </a:ext>
                  </a:extLst>
                </p:cNvPr>
                <p:cNvSpPr/>
                <p:nvPr/>
              </p:nvSpPr>
              <p:spPr>
                <a:xfrm>
                  <a:off x="4709158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8" name="Rectangle 637">
                  <a:extLst>
                    <a:ext uri="{FF2B5EF4-FFF2-40B4-BE49-F238E27FC236}">
                      <a16:creationId xmlns:a16="http://schemas.microsoft.com/office/drawing/2014/main" id="{C9E5F74A-5794-CF15-4633-49348512BECB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9" name="Rectangle 638">
                  <a:extLst>
                    <a:ext uri="{FF2B5EF4-FFF2-40B4-BE49-F238E27FC236}">
                      <a16:creationId xmlns:a16="http://schemas.microsoft.com/office/drawing/2014/main" id="{C4059AF6-DAC1-9680-B70A-5558B0195C48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0" name="Rectangle 639">
                  <a:extLst>
                    <a:ext uri="{FF2B5EF4-FFF2-40B4-BE49-F238E27FC236}">
                      <a16:creationId xmlns:a16="http://schemas.microsoft.com/office/drawing/2014/main" id="{50B42E03-049E-3A3D-5495-2B2E6E523741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1" name="Rectangle 640">
                  <a:extLst>
                    <a:ext uri="{FF2B5EF4-FFF2-40B4-BE49-F238E27FC236}">
                      <a16:creationId xmlns:a16="http://schemas.microsoft.com/office/drawing/2014/main" id="{8A936173-C47B-E322-BB99-36DD43A0F7EB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2" name="Rectangle 641">
                  <a:extLst>
                    <a:ext uri="{FF2B5EF4-FFF2-40B4-BE49-F238E27FC236}">
                      <a16:creationId xmlns:a16="http://schemas.microsoft.com/office/drawing/2014/main" id="{E0FCE62B-8988-ABF7-2F5E-784DFF61269A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3" name="Rectangle 642">
                  <a:extLst>
                    <a:ext uri="{FF2B5EF4-FFF2-40B4-BE49-F238E27FC236}">
                      <a16:creationId xmlns:a16="http://schemas.microsoft.com/office/drawing/2014/main" id="{8B2A9A66-0182-F68A-5B20-FD39A13111B5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4" name="Rectangle 643">
                  <a:extLst>
                    <a:ext uri="{FF2B5EF4-FFF2-40B4-BE49-F238E27FC236}">
                      <a16:creationId xmlns:a16="http://schemas.microsoft.com/office/drawing/2014/main" id="{5CB2B9A8-3E97-4E57-3492-6E8AF9C5CD10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5" name="Rectangle 644">
                  <a:extLst>
                    <a:ext uri="{FF2B5EF4-FFF2-40B4-BE49-F238E27FC236}">
                      <a16:creationId xmlns:a16="http://schemas.microsoft.com/office/drawing/2014/main" id="{DC747B3C-6632-16DD-CFD6-6E469E275624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6" name="Rectangle 645">
                  <a:extLst>
                    <a:ext uri="{FF2B5EF4-FFF2-40B4-BE49-F238E27FC236}">
                      <a16:creationId xmlns:a16="http://schemas.microsoft.com/office/drawing/2014/main" id="{FB9CF02E-3200-77B3-47CB-E38239F1540D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7" name="Rectangle 646">
                  <a:extLst>
                    <a:ext uri="{FF2B5EF4-FFF2-40B4-BE49-F238E27FC236}">
                      <a16:creationId xmlns:a16="http://schemas.microsoft.com/office/drawing/2014/main" id="{80F7A825-039E-5C20-4F8A-F976DA81055B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8" name="Rectangle 647">
                  <a:extLst>
                    <a:ext uri="{FF2B5EF4-FFF2-40B4-BE49-F238E27FC236}">
                      <a16:creationId xmlns:a16="http://schemas.microsoft.com/office/drawing/2014/main" id="{AE2C5428-9EC0-872B-6A4A-FA3AA873EE31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9" name="Rectangle 648">
                  <a:extLst>
                    <a:ext uri="{FF2B5EF4-FFF2-40B4-BE49-F238E27FC236}">
                      <a16:creationId xmlns:a16="http://schemas.microsoft.com/office/drawing/2014/main" id="{A23972F3-F06A-34F5-79F8-A4E7FD652A6F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0" name="Rectangle 649">
                  <a:extLst>
                    <a:ext uri="{FF2B5EF4-FFF2-40B4-BE49-F238E27FC236}">
                      <a16:creationId xmlns:a16="http://schemas.microsoft.com/office/drawing/2014/main" id="{3CA97D52-EB6D-ED00-D371-8B0920502A56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51" name="Rectangle 650">
                  <a:extLst>
                    <a:ext uri="{FF2B5EF4-FFF2-40B4-BE49-F238E27FC236}">
                      <a16:creationId xmlns:a16="http://schemas.microsoft.com/office/drawing/2014/main" id="{6D7E0D3A-F25D-67C8-6210-A333BB1DFE9B}"/>
                    </a:ext>
                  </a:extLst>
                </p:cNvPr>
                <p:cNvSpPr/>
                <p:nvPr/>
              </p:nvSpPr>
              <p:spPr>
                <a:xfrm>
                  <a:off x="4709159" y="70081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OTAL</a:t>
                  </a:r>
                </a:p>
              </p:txBody>
            </p:sp>
          </p:grpSp>
        </p:grpSp>
        <p:grpSp>
          <p:nvGrpSpPr>
            <p:cNvPr id="583" name="Group 582">
              <a:extLst>
                <a:ext uri="{FF2B5EF4-FFF2-40B4-BE49-F238E27FC236}">
                  <a16:creationId xmlns:a16="http://schemas.microsoft.com/office/drawing/2014/main" id="{133A34DD-D905-54FC-58EC-4F9E945212F4}"/>
                </a:ext>
              </a:extLst>
            </p:cNvPr>
            <p:cNvGrpSpPr/>
            <p:nvPr/>
          </p:nvGrpSpPr>
          <p:grpSpPr>
            <a:xfrm>
              <a:off x="3965346" y="35560"/>
              <a:ext cx="2661867" cy="1784119"/>
              <a:chOff x="3965346" y="35560"/>
              <a:chExt cx="2661867" cy="1784119"/>
            </a:xfrm>
          </p:grpSpPr>
          <p:grpSp>
            <p:nvGrpSpPr>
              <p:cNvPr id="586" name="Group 585">
                <a:extLst>
                  <a:ext uri="{FF2B5EF4-FFF2-40B4-BE49-F238E27FC236}">
                    <a16:creationId xmlns:a16="http://schemas.microsoft.com/office/drawing/2014/main" id="{7741DB0C-A5EC-AD70-CE17-5D3C51DFC4EF}"/>
                  </a:ext>
                </a:extLst>
              </p:cNvPr>
              <p:cNvGrpSpPr/>
              <p:nvPr/>
            </p:nvGrpSpPr>
            <p:grpSpPr>
              <a:xfrm>
                <a:off x="4754016" y="35560"/>
                <a:ext cx="685800" cy="1784119"/>
                <a:chOff x="4709160" y="75161"/>
                <a:chExt cx="685800" cy="1784119"/>
              </a:xfrm>
            </p:grpSpPr>
            <p:sp>
              <p:nvSpPr>
                <p:cNvPr id="619" name="Rectangle 618">
                  <a:extLst>
                    <a:ext uri="{FF2B5EF4-FFF2-40B4-BE49-F238E27FC236}">
                      <a16:creationId xmlns:a16="http://schemas.microsoft.com/office/drawing/2014/main" id="{5A817E0B-A280-FE14-1D00-A112AC6C542D}"/>
                    </a:ext>
                  </a:extLst>
                </p:cNvPr>
                <p:cNvSpPr/>
                <p:nvPr/>
              </p:nvSpPr>
              <p:spPr>
                <a:xfrm>
                  <a:off x="4709160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0" name="Rectangle 619">
                  <a:extLst>
                    <a:ext uri="{FF2B5EF4-FFF2-40B4-BE49-F238E27FC236}">
                      <a16:creationId xmlns:a16="http://schemas.microsoft.com/office/drawing/2014/main" id="{1AB3BEC3-30E6-2C4F-81F2-49A2678FF98B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1" name="Rectangle 620">
                  <a:extLst>
                    <a:ext uri="{FF2B5EF4-FFF2-40B4-BE49-F238E27FC236}">
                      <a16:creationId xmlns:a16="http://schemas.microsoft.com/office/drawing/2014/main" id="{41282127-40D0-63DE-A14D-451DAD347326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2" name="Rectangle 621">
                  <a:extLst>
                    <a:ext uri="{FF2B5EF4-FFF2-40B4-BE49-F238E27FC236}">
                      <a16:creationId xmlns:a16="http://schemas.microsoft.com/office/drawing/2014/main" id="{9E050FAA-F86F-5373-6AD6-08CE52713BE6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3" name="Rectangle 622">
                  <a:extLst>
                    <a:ext uri="{FF2B5EF4-FFF2-40B4-BE49-F238E27FC236}">
                      <a16:creationId xmlns:a16="http://schemas.microsoft.com/office/drawing/2014/main" id="{F5856C0B-6EEF-D4E5-5A75-30AA099EBAC5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4" name="Rectangle 623">
                  <a:extLst>
                    <a:ext uri="{FF2B5EF4-FFF2-40B4-BE49-F238E27FC236}">
                      <a16:creationId xmlns:a16="http://schemas.microsoft.com/office/drawing/2014/main" id="{AF51987C-A4B7-10F0-DB1E-3C4F26ED3FB7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5" name="Rectangle 624">
                  <a:extLst>
                    <a:ext uri="{FF2B5EF4-FFF2-40B4-BE49-F238E27FC236}">
                      <a16:creationId xmlns:a16="http://schemas.microsoft.com/office/drawing/2014/main" id="{8264E9A9-7112-AC29-1D7D-1ACF90E5BCB8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6" name="Rectangle 625">
                  <a:extLst>
                    <a:ext uri="{FF2B5EF4-FFF2-40B4-BE49-F238E27FC236}">
                      <a16:creationId xmlns:a16="http://schemas.microsoft.com/office/drawing/2014/main" id="{A357D060-25CF-C8F4-D292-DB40D4E09EF3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7" name="Rectangle 626">
                  <a:extLst>
                    <a:ext uri="{FF2B5EF4-FFF2-40B4-BE49-F238E27FC236}">
                      <a16:creationId xmlns:a16="http://schemas.microsoft.com/office/drawing/2014/main" id="{F54D5682-D1D7-2B6D-3556-9C29A45993E7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8" name="Rectangle 627">
                  <a:extLst>
                    <a:ext uri="{FF2B5EF4-FFF2-40B4-BE49-F238E27FC236}">
                      <a16:creationId xmlns:a16="http://schemas.microsoft.com/office/drawing/2014/main" id="{836FD75D-F39E-71E6-7900-E9AF64EE6F57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29" name="Rectangle 628">
                  <a:extLst>
                    <a:ext uri="{FF2B5EF4-FFF2-40B4-BE49-F238E27FC236}">
                      <a16:creationId xmlns:a16="http://schemas.microsoft.com/office/drawing/2014/main" id="{A6D4992A-A716-06AD-C6D5-BBFDBA96F0AB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0" name="Rectangle 629">
                  <a:extLst>
                    <a:ext uri="{FF2B5EF4-FFF2-40B4-BE49-F238E27FC236}">
                      <a16:creationId xmlns:a16="http://schemas.microsoft.com/office/drawing/2014/main" id="{5DE3D62F-C61D-CADB-ED43-2865B40B340B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1" name="Rectangle 630">
                  <a:extLst>
                    <a:ext uri="{FF2B5EF4-FFF2-40B4-BE49-F238E27FC236}">
                      <a16:creationId xmlns:a16="http://schemas.microsoft.com/office/drawing/2014/main" id="{65AE6549-33F1-66F8-3515-BE2B9AF05BDE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2" name="Rectangle 631">
                  <a:extLst>
                    <a:ext uri="{FF2B5EF4-FFF2-40B4-BE49-F238E27FC236}">
                      <a16:creationId xmlns:a16="http://schemas.microsoft.com/office/drawing/2014/main" id="{65470BAB-363D-BAEB-6E93-51B8F1912D60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33" name="Rectangle 632">
                  <a:extLst>
                    <a:ext uri="{FF2B5EF4-FFF2-40B4-BE49-F238E27FC236}">
                      <a16:creationId xmlns:a16="http://schemas.microsoft.com/office/drawing/2014/main" id="{4741FB5D-D2AE-5A4F-6050-E5CA6A866EB5}"/>
                    </a:ext>
                  </a:extLst>
                </p:cNvPr>
                <p:cNvSpPr/>
                <p:nvPr/>
              </p:nvSpPr>
              <p:spPr>
                <a:xfrm>
                  <a:off x="4709160" y="75161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SOLV</a:t>
                  </a:r>
                </a:p>
              </p:txBody>
            </p:sp>
          </p:grpSp>
          <p:grpSp>
            <p:nvGrpSpPr>
              <p:cNvPr id="587" name="Group 586">
                <a:extLst>
                  <a:ext uri="{FF2B5EF4-FFF2-40B4-BE49-F238E27FC236}">
                    <a16:creationId xmlns:a16="http://schemas.microsoft.com/office/drawing/2014/main" id="{D06465E4-8D9E-67B6-7E31-D6EF35B8F467}"/>
                  </a:ext>
                </a:extLst>
              </p:cNvPr>
              <p:cNvGrpSpPr/>
              <p:nvPr/>
            </p:nvGrpSpPr>
            <p:grpSpPr>
              <a:xfrm>
                <a:off x="3965346" y="35560"/>
                <a:ext cx="685800" cy="1781493"/>
                <a:chOff x="4709160" y="77787"/>
                <a:chExt cx="685800" cy="1781493"/>
              </a:xfrm>
            </p:grpSpPr>
            <p:sp>
              <p:nvSpPr>
                <p:cNvPr id="604" name="Rectangle 603">
                  <a:extLst>
                    <a:ext uri="{FF2B5EF4-FFF2-40B4-BE49-F238E27FC236}">
                      <a16:creationId xmlns:a16="http://schemas.microsoft.com/office/drawing/2014/main" id="{35A3041F-B2CC-DFBC-B0C1-EAC7F5B7A4AA}"/>
                    </a:ext>
                  </a:extLst>
                </p:cNvPr>
                <p:cNvSpPr/>
                <p:nvPr/>
              </p:nvSpPr>
              <p:spPr>
                <a:xfrm>
                  <a:off x="4709160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5" name="Rectangle 604">
                  <a:extLst>
                    <a:ext uri="{FF2B5EF4-FFF2-40B4-BE49-F238E27FC236}">
                      <a16:creationId xmlns:a16="http://schemas.microsoft.com/office/drawing/2014/main" id="{4BEDE9C5-E49D-6BD3-5CBB-E6CDC42AE745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6" name="Rectangle 605">
                  <a:extLst>
                    <a:ext uri="{FF2B5EF4-FFF2-40B4-BE49-F238E27FC236}">
                      <a16:creationId xmlns:a16="http://schemas.microsoft.com/office/drawing/2014/main" id="{304ED38C-C19E-7A78-B62A-5D0F3D1BA8A8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7" name="Rectangle 606">
                  <a:extLst>
                    <a:ext uri="{FF2B5EF4-FFF2-40B4-BE49-F238E27FC236}">
                      <a16:creationId xmlns:a16="http://schemas.microsoft.com/office/drawing/2014/main" id="{9A7C7F6C-71B3-E1A6-FF84-4BBAFAA28683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8" name="Rectangle 607">
                  <a:extLst>
                    <a:ext uri="{FF2B5EF4-FFF2-40B4-BE49-F238E27FC236}">
                      <a16:creationId xmlns:a16="http://schemas.microsoft.com/office/drawing/2014/main" id="{B172ECBA-2D21-5F78-74A1-6A7AF9A8AD96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9" name="Rectangle 608">
                  <a:extLst>
                    <a:ext uri="{FF2B5EF4-FFF2-40B4-BE49-F238E27FC236}">
                      <a16:creationId xmlns:a16="http://schemas.microsoft.com/office/drawing/2014/main" id="{8FE8190A-1CC2-9A26-078B-9E42F73CF2A5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0" name="Rectangle 609">
                  <a:extLst>
                    <a:ext uri="{FF2B5EF4-FFF2-40B4-BE49-F238E27FC236}">
                      <a16:creationId xmlns:a16="http://schemas.microsoft.com/office/drawing/2014/main" id="{E9053E2D-B1FC-413A-333C-4BF016F521CF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1" name="Rectangle 610">
                  <a:extLst>
                    <a:ext uri="{FF2B5EF4-FFF2-40B4-BE49-F238E27FC236}">
                      <a16:creationId xmlns:a16="http://schemas.microsoft.com/office/drawing/2014/main" id="{2BC61A5E-504B-9C01-3727-2C22D2C76A97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2" name="Rectangle 611">
                  <a:extLst>
                    <a:ext uri="{FF2B5EF4-FFF2-40B4-BE49-F238E27FC236}">
                      <a16:creationId xmlns:a16="http://schemas.microsoft.com/office/drawing/2014/main" id="{1D4E11B1-DB7E-7696-35B8-952AF85ACDDE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3" name="Rectangle 612">
                  <a:extLst>
                    <a:ext uri="{FF2B5EF4-FFF2-40B4-BE49-F238E27FC236}">
                      <a16:creationId xmlns:a16="http://schemas.microsoft.com/office/drawing/2014/main" id="{2B6F4FCC-8970-4279-281C-449B313C6523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4" name="Rectangle 613">
                  <a:extLst>
                    <a:ext uri="{FF2B5EF4-FFF2-40B4-BE49-F238E27FC236}">
                      <a16:creationId xmlns:a16="http://schemas.microsoft.com/office/drawing/2014/main" id="{F76769F3-9F53-857F-40A2-2D44318A7FD6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5" name="Rectangle 614">
                  <a:extLst>
                    <a:ext uri="{FF2B5EF4-FFF2-40B4-BE49-F238E27FC236}">
                      <a16:creationId xmlns:a16="http://schemas.microsoft.com/office/drawing/2014/main" id="{C9A4A9D6-9B26-D953-78CA-FFBA7D1E3D5D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6" name="Rectangle 615">
                  <a:extLst>
                    <a:ext uri="{FF2B5EF4-FFF2-40B4-BE49-F238E27FC236}">
                      <a16:creationId xmlns:a16="http://schemas.microsoft.com/office/drawing/2014/main" id="{40BFB2F7-8FB4-CE04-F03F-FFAAF95213D4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7" name="Rectangle 616">
                  <a:extLst>
                    <a:ext uri="{FF2B5EF4-FFF2-40B4-BE49-F238E27FC236}">
                      <a16:creationId xmlns:a16="http://schemas.microsoft.com/office/drawing/2014/main" id="{4266E87A-789B-1F49-00BB-E32B7F32FEEC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8" name="Rectangle 617">
                  <a:extLst>
                    <a:ext uri="{FF2B5EF4-FFF2-40B4-BE49-F238E27FC236}">
                      <a16:creationId xmlns:a16="http://schemas.microsoft.com/office/drawing/2014/main" id="{329C1BDD-F74F-8CA1-D78F-B00E72BE736E}"/>
                    </a:ext>
                  </a:extLst>
                </p:cNvPr>
                <p:cNvSpPr/>
                <p:nvPr/>
              </p:nvSpPr>
              <p:spPr>
                <a:xfrm>
                  <a:off x="4709160" y="77787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GAS</a:t>
                  </a:r>
                </a:p>
              </p:txBody>
            </p:sp>
          </p:grpSp>
          <p:grpSp>
            <p:nvGrpSpPr>
              <p:cNvPr id="588" name="Group 587">
                <a:extLst>
                  <a:ext uri="{FF2B5EF4-FFF2-40B4-BE49-F238E27FC236}">
                    <a16:creationId xmlns:a16="http://schemas.microsoft.com/office/drawing/2014/main" id="{F70016BE-9002-795B-5FE6-4938C1A4B394}"/>
                  </a:ext>
                </a:extLst>
              </p:cNvPr>
              <p:cNvGrpSpPr/>
              <p:nvPr/>
            </p:nvGrpSpPr>
            <p:grpSpPr>
              <a:xfrm>
                <a:off x="5542687" y="35560"/>
                <a:ext cx="1084526" cy="1781493"/>
                <a:chOff x="4709159" y="77787"/>
                <a:chExt cx="685801" cy="1781493"/>
              </a:xfrm>
            </p:grpSpPr>
            <p:sp>
              <p:nvSpPr>
                <p:cNvPr id="589" name="Rectangle 588">
                  <a:extLst>
                    <a:ext uri="{FF2B5EF4-FFF2-40B4-BE49-F238E27FC236}">
                      <a16:creationId xmlns:a16="http://schemas.microsoft.com/office/drawing/2014/main" id="{6CF1119F-2A2D-B471-01F9-7A5D759BAB05}"/>
                    </a:ext>
                  </a:extLst>
                </p:cNvPr>
                <p:cNvSpPr/>
                <p:nvPr/>
              </p:nvSpPr>
              <p:spPr>
                <a:xfrm>
                  <a:off x="4709160" y="24384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0" name="Rectangle 589">
                  <a:extLst>
                    <a:ext uri="{FF2B5EF4-FFF2-40B4-BE49-F238E27FC236}">
                      <a16:creationId xmlns:a16="http://schemas.microsoft.com/office/drawing/2014/main" id="{D3A74B4A-1B61-9DE3-5276-1F395A36E21A}"/>
                    </a:ext>
                  </a:extLst>
                </p:cNvPr>
                <p:cNvSpPr/>
                <p:nvPr/>
              </p:nvSpPr>
              <p:spPr>
                <a:xfrm>
                  <a:off x="4709160" y="35989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1" name="Rectangle 590">
                  <a:extLst>
                    <a:ext uri="{FF2B5EF4-FFF2-40B4-BE49-F238E27FC236}">
                      <a16:creationId xmlns:a16="http://schemas.microsoft.com/office/drawing/2014/main" id="{4FBD1496-27F3-65FA-8F33-5D1A9CDC36C4}"/>
                    </a:ext>
                  </a:extLst>
                </p:cNvPr>
                <p:cNvSpPr/>
                <p:nvPr/>
              </p:nvSpPr>
              <p:spPr>
                <a:xfrm>
                  <a:off x="4709160" y="47595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2" name="Rectangle 591">
                  <a:extLst>
                    <a:ext uri="{FF2B5EF4-FFF2-40B4-BE49-F238E27FC236}">
                      <a16:creationId xmlns:a16="http://schemas.microsoft.com/office/drawing/2014/main" id="{676F8A71-F2AC-E335-AFC2-E9FDCCFE39F5}"/>
                    </a:ext>
                  </a:extLst>
                </p:cNvPr>
                <p:cNvSpPr/>
                <p:nvPr/>
              </p:nvSpPr>
              <p:spPr>
                <a:xfrm>
                  <a:off x="4709160" y="59201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3" name="Rectangle 592">
                  <a:extLst>
                    <a:ext uri="{FF2B5EF4-FFF2-40B4-BE49-F238E27FC236}">
                      <a16:creationId xmlns:a16="http://schemas.microsoft.com/office/drawing/2014/main" id="{8BFF6D84-423C-FBC8-0502-0AB7F8A3F01D}"/>
                    </a:ext>
                  </a:extLst>
                </p:cNvPr>
                <p:cNvSpPr/>
                <p:nvPr/>
              </p:nvSpPr>
              <p:spPr>
                <a:xfrm>
                  <a:off x="4709160" y="70807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4" name="Rectangle 593">
                  <a:extLst>
                    <a:ext uri="{FF2B5EF4-FFF2-40B4-BE49-F238E27FC236}">
                      <a16:creationId xmlns:a16="http://schemas.microsoft.com/office/drawing/2014/main" id="{48C0C52B-21DE-3C46-EA62-16DD01C6C41E}"/>
                    </a:ext>
                  </a:extLst>
                </p:cNvPr>
                <p:cNvSpPr/>
                <p:nvPr/>
              </p:nvSpPr>
              <p:spPr>
                <a:xfrm>
                  <a:off x="4709160" y="82413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5" name="Rectangle 594">
                  <a:extLst>
                    <a:ext uri="{FF2B5EF4-FFF2-40B4-BE49-F238E27FC236}">
                      <a16:creationId xmlns:a16="http://schemas.microsoft.com/office/drawing/2014/main" id="{6A1972B7-0150-A5E6-1586-65FA8F07D7E9}"/>
                    </a:ext>
                  </a:extLst>
                </p:cNvPr>
                <p:cNvSpPr/>
                <p:nvPr/>
              </p:nvSpPr>
              <p:spPr>
                <a:xfrm>
                  <a:off x="4709160" y="94018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6" name="Rectangle 595">
                  <a:extLst>
                    <a:ext uri="{FF2B5EF4-FFF2-40B4-BE49-F238E27FC236}">
                      <a16:creationId xmlns:a16="http://schemas.microsoft.com/office/drawing/2014/main" id="{F9FE110D-5768-7A85-CEA7-550F9AB32FBE}"/>
                    </a:ext>
                  </a:extLst>
                </p:cNvPr>
                <p:cNvSpPr/>
                <p:nvPr/>
              </p:nvSpPr>
              <p:spPr>
                <a:xfrm>
                  <a:off x="4709160" y="105624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7" name="Rectangle 596">
                  <a:extLst>
                    <a:ext uri="{FF2B5EF4-FFF2-40B4-BE49-F238E27FC236}">
                      <a16:creationId xmlns:a16="http://schemas.microsoft.com/office/drawing/2014/main" id="{9591B10F-4137-0B36-CA45-E6D44DD79DCB}"/>
                    </a:ext>
                  </a:extLst>
                </p:cNvPr>
                <p:cNvSpPr/>
                <p:nvPr/>
              </p:nvSpPr>
              <p:spPr>
                <a:xfrm>
                  <a:off x="4709160" y="1172304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8" name="Rectangle 597">
                  <a:extLst>
                    <a:ext uri="{FF2B5EF4-FFF2-40B4-BE49-F238E27FC236}">
                      <a16:creationId xmlns:a16="http://schemas.microsoft.com/office/drawing/2014/main" id="{AB65A362-47CF-14E6-A1F0-E234F78D9E78}"/>
                    </a:ext>
                  </a:extLst>
                </p:cNvPr>
                <p:cNvSpPr/>
                <p:nvPr/>
              </p:nvSpPr>
              <p:spPr>
                <a:xfrm>
                  <a:off x="4709160" y="1288362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99" name="Rectangle 598">
                  <a:extLst>
                    <a:ext uri="{FF2B5EF4-FFF2-40B4-BE49-F238E27FC236}">
                      <a16:creationId xmlns:a16="http://schemas.microsoft.com/office/drawing/2014/main" id="{932717B0-63EE-D69A-D71F-B6B7B5DE2E33}"/>
                    </a:ext>
                  </a:extLst>
                </p:cNvPr>
                <p:cNvSpPr/>
                <p:nvPr/>
              </p:nvSpPr>
              <p:spPr>
                <a:xfrm>
                  <a:off x="4709160" y="140442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0" name="Rectangle 599">
                  <a:extLst>
                    <a:ext uri="{FF2B5EF4-FFF2-40B4-BE49-F238E27FC236}">
                      <a16:creationId xmlns:a16="http://schemas.microsoft.com/office/drawing/2014/main" id="{85478EA5-1B08-F8B1-ECDB-5644B7C80BDB}"/>
                    </a:ext>
                  </a:extLst>
                </p:cNvPr>
                <p:cNvSpPr/>
                <p:nvPr/>
              </p:nvSpPr>
              <p:spPr>
                <a:xfrm>
                  <a:off x="4709160" y="1520478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1" name="Rectangle 600">
                  <a:extLst>
                    <a:ext uri="{FF2B5EF4-FFF2-40B4-BE49-F238E27FC236}">
                      <a16:creationId xmlns:a16="http://schemas.microsoft.com/office/drawing/2014/main" id="{43F9D02A-B6EC-F828-FD77-A54F72A00414}"/>
                    </a:ext>
                  </a:extLst>
                </p:cNvPr>
                <p:cNvSpPr/>
                <p:nvPr/>
              </p:nvSpPr>
              <p:spPr>
                <a:xfrm>
                  <a:off x="4709160" y="1636536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2" name="Rectangle 601">
                  <a:extLst>
                    <a:ext uri="{FF2B5EF4-FFF2-40B4-BE49-F238E27FC236}">
                      <a16:creationId xmlns:a16="http://schemas.microsoft.com/office/drawing/2014/main" id="{A717B5FE-D552-4A3E-4FAE-2056E490C0C1}"/>
                    </a:ext>
                  </a:extLst>
                </p:cNvPr>
                <p:cNvSpPr/>
                <p:nvPr/>
              </p:nvSpPr>
              <p:spPr>
                <a:xfrm>
                  <a:off x="4709160" y="1752600"/>
                  <a:ext cx="685800" cy="106680"/>
                </a:xfrm>
                <a:prstGeom prst="rect">
                  <a:avLst/>
                </a:prstGeom>
                <a:solidFill>
                  <a:schemeClr val="bg2"/>
                </a:solidFill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03" name="Rectangle 602">
                  <a:extLst>
                    <a:ext uri="{FF2B5EF4-FFF2-40B4-BE49-F238E27FC236}">
                      <a16:creationId xmlns:a16="http://schemas.microsoft.com/office/drawing/2014/main" id="{5C68D1E6-2E77-6339-C06C-4C3449852D3B}"/>
                    </a:ext>
                  </a:extLst>
                </p:cNvPr>
                <p:cNvSpPr/>
                <p:nvPr/>
              </p:nvSpPr>
              <p:spPr>
                <a:xfrm>
                  <a:off x="4709159" y="77787"/>
                  <a:ext cx="685800" cy="10668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OTAL</a:t>
                  </a:r>
                </a:p>
              </p:txBody>
            </p:sp>
          </p:grpSp>
        </p:grpSp>
        <p:graphicFrame>
          <p:nvGraphicFramePr>
            <p:cNvPr id="584" name="Chart 583">
              <a:extLst>
                <a:ext uri="{FF2B5EF4-FFF2-40B4-BE49-F238E27FC236}">
                  <a16:creationId xmlns:a16="http://schemas.microsoft.com/office/drawing/2014/main" id="{F95554C0-3967-1976-6FF7-7B39A37BDE5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8391881"/>
                </p:ext>
              </p:extLst>
            </p:nvPr>
          </p:nvGraphicFramePr>
          <p:xfrm>
            <a:off x="41765" y="-21794"/>
            <a:ext cx="3379602" cy="21147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85" name="Chart 584">
              <a:extLst>
                <a:ext uri="{FF2B5EF4-FFF2-40B4-BE49-F238E27FC236}">
                  <a16:creationId xmlns:a16="http://schemas.microsoft.com/office/drawing/2014/main" id="{07DF1147-EF34-0627-A164-ADA79EF747D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5115426"/>
                </p:ext>
              </p:extLst>
            </p:nvPr>
          </p:nvGraphicFramePr>
          <p:xfrm>
            <a:off x="3429000" y="-21794"/>
            <a:ext cx="3379602" cy="21147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aphicFrame>
        <p:nvGraphicFramePr>
          <p:cNvPr id="682" name="Chart 681">
            <a:extLst>
              <a:ext uri="{FF2B5EF4-FFF2-40B4-BE49-F238E27FC236}">
                <a16:creationId xmlns:a16="http://schemas.microsoft.com/office/drawing/2014/main" id="{B0D9B5E0-1B84-4AF6-AB01-AB6148B436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584708"/>
              </p:ext>
            </p:extLst>
          </p:nvPr>
        </p:nvGraphicFramePr>
        <p:xfrm>
          <a:off x="45581" y="2148841"/>
          <a:ext cx="3379602" cy="2010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83" name="Chart 682">
            <a:extLst>
              <a:ext uri="{FF2B5EF4-FFF2-40B4-BE49-F238E27FC236}">
                <a16:creationId xmlns:a16="http://schemas.microsoft.com/office/drawing/2014/main" id="{80D9163E-FE4C-5C5A-CA5F-AF11400EA6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8997737"/>
              </p:ext>
            </p:extLst>
          </p:nvPr>
        </p:nvGraphicFramePr>
        <p:xfrm>
          <a:off x="45581" y="4172293"/>
          <a:ext cx="3379602" cy="20848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84" name="Chart 683">
            <a:extLst>
              <a:ext uri="{FF2B5EF4-FFF2-40B4-BE49-F238E27FC236}">
                <a16:creationId xmlns:a16="http://schemas.microsoft.com/office/drawing/2014/main" id="{7FA20F06-4227-46DE-8800-38C334D9D2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0500347"/>
              </p:ext>
            </p:extLst>
          </p:nvPr>
        </p:nvGraphicFramePr>
        <p:xfrm>
          <a:off x="3432816" y="2148841"/>
          <a:ext cx="3379602" cy="2010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85" name="Chart 684">
            <a:extLst>
              <a:ext uri="{FF2B5EF4-FFF2-40B4-BE49-F238E27FC236}">
                <a16:creationId xmlns:a16="http://schemas.microsoft.com/office/drawing/2014/main" id="{DB73D9B4-0FB6-DEE0-A605-4019F3E3F5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3066042"/>
              </p:ext>
            </p:extLst>
          </p:nvPr>
        </p:nvGraphicFramePr>
        <p:xfrm>
          <a:off x="3432816" y="4172293"/>
          <a:ext cx="3379529" cy="20848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86" name="Rectangle 685">
            <a:extLst>
              <a:ext uri="{FF2B5EF4-FFF2-40B4-BE49-F238E27FC236}">
                <a16:creationId xmlns:a16="http://schemas.microsoft.com/office/drawing/2014/main" id="{070AA2FE-8F5B-3C1E-3966-62C70F5437BA}"/>
              </a:ext>
            </a:extLst>
          </p:cNvPr>
          <p:cNvSpPr/>
          <p:nvPr/>
        </p:nvSpPr>
        <p:spPr>
          <a:xfrm>
            <a:off x="53214" y="20750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87" name="Rectangle 686">
            <a:extLst>
              <a:ext uri="{FF2B5EF4-FFF2-40B4-BE49-F238E27FC236}">
                <a16:creationId xmlns:a16="http://schemas.microsoft.com/office/drawing/2014/main" id="{06E294C1-FEE8-6FA8-C04B-EFD040995DD2}"/>
              </a:ext>
            </a:extLst>
          </p:cNvPr>
          <p:cNvSpPr/>
          <p:nvPr/>
        </p:nvSpPr>
        <p:spPr>
          <a:xfrm>
            <a:off x="3429000" y="20750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88" name="Rectangle 687">
            <a:extLst>
              <a:ext uri="{FF2B5EF4-FFF2-40B4-BE49-F238E27FC236}">
                <a16:creationId xmlns:a16="http://schemas.microsoft.com/office/drawing/2014/main" id="{9FAC125D-3EF8-3C55-1E27-00026795AE85}"/>
              </a:ext>
            </a:extLst>
          </p:cNvPr>
          <p:cNvSpPr/>
          <p:nvPr/>
        </p:nvSpPr>
        <p:spPr>
          <a:xfrm>
            <a:off x="53214" y="2148841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89" name="Rectangle 688">
            <a:extLst>
              <a:ext uri="{FF2B5EF4-FFF2-40B4-BE49-F238E27FC236}">
                <a16:creationId xmlns:a16="http://schemas.microsoft.com/office/drawing/2014/main" id="{D4350E0E-3FD7-35D9-013E-01441C6CB09D}"/>
              </a:ext>
            </a:extLst>
          </p:cNvPr>
          <p:cNvSpPr/>
          <p:nvPr/>
        </p:nvSpPr>
        <p:spPr>
          <a:xfrm>
            <a:off x="3429000" y="2148841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90" name="Rectangle 689">
            <a:extLst>
              <a:ext uri="{FF2B5EF4-FFF2-40B4-BE49-F238E27FC236}">
                <a16:creationId xmlns:a16="http://schemas.microsoft.com/office/drawing/2014/main" id="{5F35CB74-3169-E8A5-92D7-DEA459D1E680}"/>
              </a:ext>
            </a:extLst>
          </p:cNvPr>
          <p:cNvSpPr/>
          <p:nvPr/>
        </p:nvSpPr>
        <p:spPr>
          <a:xfrm>
            <a:off x="57030" y="4172293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91" name="Rectangle 690">
            <a:extLst>
              <a:ext uri="{FF2B5EF4-FFF2-40B4-BE49-F238E27FC236}">
                <a16:creationId xmlns:a16="http://schemas.microsoft.com/office/drawing/2014/main" id="{C9733599-4B50-C38F-9389-77D71A5D78FA}"/>
              </a:ext>
            </a:extLst>
          </p:cNvPr>
          <p:cNvSpPr/>
          <p:nvPr/>
        </p:nvSpPr>
        <p:spPr>
          <a:xfrm>
            <a:off x="3432816" y="4172293"/>
            <a:ext cx="274459" cy="22828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1805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2</TotalTime>
  <Words>57</Words>
  <Application>Microsoft Office PowerPoint</Application>
  <PresentationFormat>Custom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one</dc:creator>
  <cp:lastModifiedBy>Zone</cp:lastModifiedBy>
  <cp:revision>8</cp:revision>
  <dcterms:created xsi:type="dcterms:W3CDTF">2026-04-10T06:11:33Z</dcterms:created>
  <dcterms:modified xsi:type="dcterms:W3CDTF">2026-04-12T09:23:21Z</dcterms:modified>
</cp:coreProperties>
</file>